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6" r:id="rId2"/>
    <p:sldId id="300" r:id="rId3"/>
    <p:sldId id="301" r:id="rId4"/>
    <p:sldId id="302" r:id="rId5"/>
    <p:sldId id="259" r:id="rId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153"/>
    <p:restoredTop sz="95884"/>
  </p:normalViewPr>
  <p:slideViewPr>
    <p:cSldViewPr snapToGrid="0" showGuides="1">
      <p:cViewPr varScale="1">
        <p:scale>
          <a:sx n="93" d="100"/>
          <a:sy n="93" d="100"/>
        </p:scale>
        <p:origin x="240" y="7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048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247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284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657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864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7722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20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891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716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41028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0961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C37C6-9D1C-434B-A4AC-B9E896E0C7C7}" type="datetimeFigureOut">
              <a:rPr kumimoji="1" lang="ja-JP" altLang="en-US" smtClean="0"/>
              <a:t>2025/10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00A62-F823-F84B-BE03-61B7C6BA0B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883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4D9FF7E-C279-8CBE-C1DF-90AC4575BF0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66FA68F-7130-86A3-E976-051BC1E2768B}"/>
              </a:ext>
            </a:extLst>
          </p:cNvPr>
          <p:cNvSpPr txBox="1"/>
          <p:nvPr/>
        </p:nvSpPr>
        <p:spPr>
          <a:xfrm>
            <a:off x="90697" y="134237"/>
            <a:ext cx="507434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E2D328D-3015-1C76-16BD-86F059B27509}"/>
              </a:ext>
            </a:extLst>
          </p:cNvPr>
          <p:cNvSpPr txBox="1"/>
          <p:nvPr/>
        </p:nvSpPr>
        <p:spPr>
          <a:xfrm>
            <a:off x="344669" y="1150345"/>
            <a:ext cx="60226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 S1  Ingredients of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am-type moisturizer</a:t>
            </a:r>
            <a:r>
              <a:rPr lang="ja-JP" altLang="ja-JP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ja-JP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B5D30BDE-3AC7-C9D3-6CBE-4228AB2CA0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7995866"/>
              </p:ext>
            </p:extLst>
          </p:nvPr>
        </p:nvGraphicFramePr>
        <p:xfrm>
          <a:off x="887097" y="1601693"/>
          <a:ext cx="4277940" cy="2163376"/>
        </p:xfrm>
        <a:graphic>
          <a:graphicData uri="http://schemas.openxmlformats.org/drawingml/2006/table">
            <a:tbl>
              <a:tblPr/>
              <a:tblGrid>
                <a:gridCol w="2069657">
                  <a:extLst>
                    <a:ext uri="{9D8B030D-6E8A-4147-A177-3AD203B41FA5}">
                      <a16:colId xmlns:a16="http://schemas.microsoft.com/office/drawing/2014/main" val="3913091978"/>
                    </a:ext>
                  </a:extLst>
                </a:gridCol>
                <a:gridCol w="2208283">
                  <a:extLst>
                    <a:ext uri="{9D8B030D-6E8A-4147-A177-3AD203B41FA5}">
                      <a16:colId xmlns:a16="http://schemas.microsoft.com/office/drawing/2014/main" val="2412362744"/>
                    </a:ext>
                  </a:extLst>
                </a:gridCol>
              </a:tblGrid>
              <a:tr h="19083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water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agarame extract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2676874"/>
                  </a:ext>
                </a:extLst>
              </a:tr>
              <a:tr h="28344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glycerin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andarin orange peel extract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6360814"/>
                  </a:ext>
                </a:extLst>
              </a:tr>
              <a:tr h="19083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ethylhexyl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palmitate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ipotassium glycyrrhizate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462169"/>
                  </a:ext>
                </a:extLst>
              </a:tr>
              <a:tr h="28344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Olea europaea</a:t>
                      </a: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 (olive) fruit oil</a:t>
                      </a:r>
                      <a:endParaRPr lang="en-US" sz="105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sorbitan palmitate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9516519"/>
                  </a:ext>
                </a:extLst>
              </a:tr>
              <a:tr h="136422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olyglyceryl-10 </a:t>
                      </a:r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iisostearat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copherol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9286972"/>
                  </a:ext>
                </a:extLst>
              </a:tr>
              <a:tr h="283441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hydrogenated rapeseed alcohol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ethylhexylglycerin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2624251"/>
                  </a:ext>
                </a:extLst>
              </a:tr>
              <a:tr h="19083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olysorbate 60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henoxyethanol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9578039"/>
                  </a:ext>
                </a:extLst>
              </a:tr>
              <a:tr h="19083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behenyl alcohol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arbomer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572539"/>
                  </a:ext>
                </a:extLst>
              </a:tr>
              <a:tr h="190839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imethicone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otassium hydroxide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4033226"/>
                  </a:ext>
                </a:extLst>
              </a:tr>
              <a:tr h="190839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butylene glycol</a:t>
                      </a:r>
                    </a:p>
                  </a:txBody>
                  <a:tcPr marL="7999" marR="7999" marT="79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06672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59391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06C22D4-4FC3-EB84-0F10-D8C0E8BBB4F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コンテンツ プレースホルダー 2">
            <a:extLst>
              <a:ext uri="{FF2B5EF4-FFF2-40B4-BE49-F238E27FC236}">
                <a16:creationId xmlns:a16="http://schemas.microsoft.com/office/drawing/2014/main" id="{07E9404A-BE8D-B71D-0E7C-0BC018A9D1CA}"/>
              </a:ext>
            </a:extLst>
          </p:cNvPr>
          <p:cNvSpPr txBox="1">
            <a:spLocks/>
          </p:cNvSpPr>
          <p:nvPr/>
        </p:nvSpPr>
        <p:spPr>
          <a:xfrm>
            <a:off x="336584" y="5415572"/>
            <a:ext cx="11441718" cy="36933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 Comparison of AUCs for SC factors measured by confocal Raman spectrometer 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t 0,14, and 28 </a:t>
            </a:r>
            <a:r>
              <a:rPr lang="en-US" altLang="ja-JP" sz="1600" b="1" kern="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days</a:t>
            </a:r>
            <a:endParaRPr lang="ja-JP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E616BD2-E175-B32D-DE19-51165E293483}"/>
              </a:ext>
            </a:extLst>
          </p:cNvPr>
          <p:cNvSpPr txBox="1"/>
          <p:nvPr/>
        </p:nvSpPr>
        <p:spPr>
          <a:xfrm>
            <a:off x="0" y="1241975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a)</a:t>
            </a:r>
            <a:endParaRPr lang="ja-JP" altLang="ja-JP" sz="14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90E5F73-270A-0E4F-E0DB-DAE23D5FD4DB}"/>
              </a:ext>
            </a:extLst>
          </p:cNvPr>
          <p:cNvSpPr txBox="1"/>
          <p:nvPr/>
        </p:nvSpPr>
        <p:spPr>
          <a:xfrm>
            <a:off x="0" y="3269538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b)</a:t>
            </a:r>
            <a:endParaRPr lang="ja-JP" altLang="ja-JP" sz="1400"/>
          </a:p>
        </p:txBody>
      </p:sp>
      <p:sp>
        <p:nvSpPr>
          <p:cNvPr id="8" name="コンテンツ プレースホルダー 2">
            <a:extLst>
              <a:ext uri="{FF2B5EF4-FFF2-40B4-BE49-F238E27FC236}">
                <a16:creationId xmlns:a16="http://schemas.microsoft.com/office/drawing/2014/main" id="{3296F5F0-E277-D7E5-8ADB-64C028B2EEC1}"/>
              </a:ext>
            </a:extLst>
          </p:cNvPr>
          <p:cNvSpPr txBox="1">
            <a:spLocks/>
          </p:cNvSpPr>
          <p:nvPr/>
        </p:nvSpPr>
        <p:spPr>
          <a:xfrm>
            <a:off x="336584" y="5784905"/>
            <a:ext cx="11441718" cy="82371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(a) water content, (b) NMF, (c) ceramide, (d) cholesterol, and (e) lactate acid,  mean and 95% CI of AUC were calculated for 0-20, 0-12, and 12-20 </a:t>
            </a:r>
            <a:r>
              <a:rPr lang="el-GR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in </a:t>
            </a:r>
            <a:r>
              <a:rPr lang="en-US" altLang="ja-JP" sz="1400" kern="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patients with and without AD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were calculated by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lch’s t-test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0 vs 14 days and 0 vs 28 days. *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, **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 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, atopic dermatitis; AUC, area under the curve; CI, confidence interval; CM, cream-type moisturizer; NMF, natural moisturizing factor; PJ, petroleum jelly.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endParaRPr lang="en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100000"/>
              </a:lnSpc>
              <a:buNone/>
            </a:pP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CFE9671-3878-8298-569F-CF3D5955F137}"/>
              </a:ext>
            </a:extLst>
          </p:cNvPr>
          <p:cNvSpPr txBox="1"/>
          <p:nvPr/>
        </p:nvSpPr>
        <p:spPr>
          <a:xfrm>
            <a:off x="559358" y="721161"/>
            <a:ext cx="12409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ja-JP" altLang="ja-JP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D547CBF1-1360-D990-052E-4CC3B982D3B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7353255"/>
              </p:ext>
            </p:extLst>
          </p:nvPr>
        </p:nvGraphicFramePr>
        <p:xfrm>
          <a:off x="559358" y="1301809"/>
          <a:ext cx="11073284" cy="1764513"/>
        </p:xfrm>
        <a:graphic>
          <a:graphicData uri="http://schemas.openxmlformats.org/drawingml/2006/table">
            <a:tbl>
              <a:tblPr/>
              <a:tblGrid>
                <a:gridCol w="311499">
                  <a:extLst>
                    <a:ext uri="{9D8B030D-6E8A-4147-A177-3AD203B41FA5}">
                      <a16:colId xmlns:a16="http://schemas.microsoft.com/office/drawing/2014/main" val="3497076943"/>
                    </a:ext>
                  </a:extLst>
                </a:gridCol>
                <a:gridCol w="281354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1015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1075174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51692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221064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1191230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376313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1065125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21547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1004836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341644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211253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1070436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326047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974690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341644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1045028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351693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Water content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249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UC (</a:t>
                      </a:r>
                      <a:r>
                        <a:rPr lang="el-G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7.07 (917.98 - 956.1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9.82 (907.81 - 951.8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15.15(883.11-947.2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4.49(907.90-981.08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4.97 (912.85 - 977.09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9.87(902.60-997.1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0.07(882.25-997.9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3.85 (916.44 - 951.2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9.38 (909.72 - 949.0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0.47(915.88-965.0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18.29(881.88-954.7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8.72 (908.94 - 968.5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9.27(881.12-977.4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48.18(899.12-997.2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561079"/>
                  </a:ext>
                </a:extLst>
              </a:tr>
              <a:tr h="10543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9.47 (912.68 - 946.2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7.60 (916.34 - 958.8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8.71(911.89-965.5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6.49(895.71-977.27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0.60 (894.23 - 946.98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29.61(885.90-973.3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11.60(869.37-953.8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470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4.20 (451.94 - 476.4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9.72 (446.11 - 473.3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3.10(433.43-472.7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6.34(442.87-489.81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9.09 (448.02 - 490.1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2.38(440.26-504.51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5.80(428.84-502.7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3789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3.86 (442.60 - 465.1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9.12 (436.34 - 461.9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7.01(440.65-473.37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1.23(418.02-464.4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*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9.03 (439.96 - 478.1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4.25(421.69-486.8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3.80(433.96-493.6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4853063"/>
                  </a:ext>
                </a:extLst>
              </a:tr>
              <a:tr h="13925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1.87 (441.43 - 462.30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6.24 (443.47 - 469.01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6.54(438.52-474.57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5.94(432.81-479.0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7.09 (430.20 - 463.98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2.83(423.48-482.19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41.35(415.78-466.9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39912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2.87 (464.66 - 481.07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0.10 (459.00 - 481.21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2.06(443.43-480.69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8.15(462.45-493.8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5.88 (463.60 - 488.1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7.48(460.22-494.7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4.28(451.52-497.0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  <a:tr h="842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9.99 (472.81 - 487.17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0.26 (472.55 - 487.9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3.45(474.08-492.8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7.06(462.35-491.7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9.69 (467.04 - 492.3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7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5.02(455.79-494.2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4.37(462.51-506.2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285483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7.61 (470.37 - 484.84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1.36 (471.86 - 490.85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2.16(471.51-492.8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0.55(461.55-499.56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3.51 (462.51 - 484.51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6.78(460.43-493.13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0.25(450.78-489.72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713118"/>
                  </a:ext>
                </a:extLst>
              </a:tr>
            </a:tbl>
          </a:graphicData>
        </a:graphic>
      </p:graphicFrame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59B7D0B0-83A9-A207-7B2D-6753A68F65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7052583"/>
              </p:ext>
            </p:extLst>
          </p:nvPr>
        </p:nvGraphicFramePr>
        <p:xfrm>
          <a:off x="559358" y="3440644"/>
          <a:ext cx="10179266" cy="1776483"/>
        </p:xfrm>
        <a:graphic>
          <a:graphicData uri="http://schemas.openxmlformats.org/drawingml/2006/table">
            <a:tbl>
              <a:tblPr/>
              <a:tblGrid>
                <a:gridCol w="311499">
                  <a:extLst>
                    <a:ext uri="{9D8B030D-6E8A-4147-A177-3AD203B41FA5}">
                      <a16:colId xmlns:a16="http://schemas.microsoft.com/office/drawing/2014/main" val="3497076943"/>
                    </a:ext>
                  </a:extLst>
                </a:gridCol>
                <a:gridCol w="281354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1015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788959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56839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267630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892097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345688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847493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79141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847493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379141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356839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970156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367991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802887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423747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869795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479502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MF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249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UC (</a:t>
                      </a:r>
                      <a:r>
                        <a:rPr lang="el-G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59 (8.37 - 10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07 (8.00 - 12.1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.60(7.34-13.8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54(6.13-12.9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06 (7.86 - 10.2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46(6.70-10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66(7.57-11.7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14 (7.90 - 10.3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40 (7.38 - 11.4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90(5.23-12.5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91(7.12-12.7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85 (7.45 - 10.2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61(6.20-11.0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.10(6.88-11.3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561079"/>
                  </a:ext>
                </a:extLst>
              </a:tr>
              <a:tr h="10543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24 (7.32 - 9.1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72 (7.22 - 10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50(6.11-10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95(6.45-11.4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1 (6.74 - 8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83(5.98-9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9(6.31-8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1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470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8 (7.13 - 8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28 (6.86 - 9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57(6.40-10.7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8(5.58-10.3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6 (6.75 - 8.5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3(5.76-8.7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09(6.64-9.5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3789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91 (6.90 - 8.9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14 (6.52 - 9.7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8(4.71-10.6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.60(6.90-10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65 (6.49 - 8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0(5.47-9.5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81(6.02-9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4853063"/>
                  </a:ext>
                </a:extLst>
              </a:tr>
              <a:tr h="13925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15 (6.43 - 7.8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56 (6.40 - 8.7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38(5.52-9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73(5.84-9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70 (5.91 - 7.5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69(5.22-8.1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71(5.60-7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39912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60 (1.20 - 2.0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79 (1.10 - 2.4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.02(0.83-3.2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6(0.51-2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40 (1.03 - 1.7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3(0.85-1.6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57(0.81-2.3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  <a:tr h="842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3 (0.98 - 1.4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7 (0.86 - 1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2(0.51-1.9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5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31(0.70-1.9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0 (0.90 - 1.5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1(0.64-1.5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9(0.79-1.7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285483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9 (0.87 - 1.3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7 (0.79 - 1.5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2(0.54-1.7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22(0.57-1.8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1 (0.80 - 1.2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13(0.73-1.5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8(0.64-1.1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7131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32270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5870CF-2110-A08C-FA64-E51D4CB33F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4D3DB22-B9E5-AE32-9095-AEBDF5A466D7}"/>
              </a:ext>
            </a:extLst>
          </p:cNvPr>
          <p:cNvSpPr txBox="1"/>
          <p:nvPr/>
        </p:nvSpPr>
        <p:spPr>
          <a:xfrm>
            <a:off x="199237" y="2760892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d)</a:t>
            </a:r>
            <a:endParaRPr lang="ja-JP" altLang="ja-JP" sz="14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CBB40FA-4748-3A28-423A-1331A6D924AB}"/>
              </a:ext>
            </a:extLst>
          </p:cNvPr>
          <p:cNvSpPr txBox="1"/>
          <p:nvPr/>
        </p:nvSpPr>
        <p:spPr>
          <a:xfrm>
            <a:off x="199237" y="4706434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e)</a:t>
            </a:r>
            <a:endParaRPr lang="ja-JP" altLang="ja-JP" sz="140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307C9BF-D9E8-F4D1-FFAD-B9B0F0182952}"/>
              </a:ext>
            </a:extLst>
          </p:cNvPr>
          <p:cNvSpPr txBox="1"/>
          <p:nvPr/>
        </p:nvSpPr>
        <p:spPr>
          <a:xfrm>
            <a:off x="199237" y="199796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c)</a:t>
            </a:r>
            <a:endParaRPr lang="ja-JP" altLang="ja-JP" sz="1400"/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DCE8BC1A-34F0-990D-C4BC-AB9F31B318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2779057"/>
              </p:ext>
            </p:extLst>
          </p:nvPr>
        </p:nvGraphicFramePr>
        <p:xfrm>
          <a:off x="496711" y="310114"/>
          <a:ext cx="11603849" cy="2005120"/>
        </p:xfrm>
        <a:graphic>
          <a:graphicData uri="http://schemas.openxmlformats.org/drawingml/2006/table">
            <a:tbl>
              <a:tblPr/>
              <a:tblGrid>
                <a:gridCol w="259645">
                  <a:extLst>
                    <a:ext uri="{9D8B030D-6E8A-4147-A177-3AD203B41FA5}">
                      <a16:colId xmlns:a16="http://schemas.microsoft.com/office/drawing/2014/main" val="3497076943"/>
                    </a:ext>
                  </a:extLst>
                </a:gridCol>
                <a:gridCol w="237066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169334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1308717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16272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123095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1173480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1203960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1179925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312420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130715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1203960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320040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1120140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335280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314960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03344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eramid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03344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2022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UC (</a:t>
                      </a:r>
                      <a:r>
                        <a:rPr lang="el-G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</a:t>
                      </a:r>
                    </a:p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</a:t>
                      </a:r>
                    </a:p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</a:t>
                      </a:r>
                    </a:p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06579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74.97 (1122.98 - 1226.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96.43 (1130.12 - 1262.7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10.69(1097.45-1323.9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82.16(1081.25-1283.0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51.57 (1069.91 - 1233.2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44.01(1013.96-1274.0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59.13(1020.46-1297.8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20543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31.71 (1352.05 - 1511.3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75.58 (1372.60 - 1578.5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75.40(1302.28-1648.5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75.76(1314.67-1636.8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83.85 (1261.53 - 1506.1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4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84.48(1246.56-1722.3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83.23(1162.58-1403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561079"/>
                  </a:ext>
                </a:extLst>
              </a:tr>
              <a:tr h="1316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70.19 (1300.66 - 1439.7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88.39 (1301.65 - 1475.1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1</a:t>
                      </a:r>
                    </a:p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04.21(1244.72-1563.7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</a:t>
                      </a:r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72.57(1254.16-1490.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2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50.33 (1238.39 - 1462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8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63.98(1219.84-1508.1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1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36.68(1119.76-1553.5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4704"/>
                  </a:ext>
                </a:extLst>
              </a:tr>
              <a:tr h="109787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18.85 (780.49 - 857.2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27.74 (777.59 - 877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29.92(744.95-914.9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25.55(747.87-903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09.15 (749.53 - 868.7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06.79(709.92-903.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811.51(711.99-911.0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20543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55.38 (985.83 - 1124.9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86.75 (995.87 - 1177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97.01(946.59-1247.4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&lt;0.001</a:t>
                      </a:r>
                    </a:p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76.49(932.16-1220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21.15 (914.40 - 1127.9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2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03.90(895.20-1312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38.40(831.14-1045.6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4853063"/>
                  </a:ext>
                </a:extLst>
              </a:tr>
              <a:tr h="20543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04.89 (946.82 - 1062.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11.57 (940.86 - 1082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21.64(887.61-1155.6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1</a:t>
                      </a:r>
                    </a:p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01.51(910.32-1092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97.61 (902.11 - 1093.1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2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009.64(887.49-1131.7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1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985.58(800.01-1171.1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399124"/>
                  </a:ext>
                </a:extLst>
              </a:tr>
              <a:tr h="109787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56.13 (337.47 - 374.7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68.69 (345.22 - 392.1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0.76(338.92-422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56.62(324.60-388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42.42 (313.53 - 371.3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7.23(297.74-376.7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47.62(293.34-401.9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  <a:tr h="20543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9.99 (472.81 - 487.1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8.83 (370.22 - 407.4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78.39(344.80-411.9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99.27(374.73-423.8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7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62.70 (334.15 - 391.2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0.58(328.98-432.1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44.82(306.82-382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285483"/>
                  </a:ext>
                </a:extLst>
              </a:tr>
              <a:tr h="1097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65.29 (350.79 - 379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76.82 (356.63 - 397.0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82.57(351.08-414.0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71.06(337.47-404.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52.72 (332.72 - 372.7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54.35(326.47-382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51.10(313.79-388.4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713118"/>
                  </a:ext>
                </a:extLst>
              </a:tr>
            </a:tbl>
          </a:graphicData>
        </a:graphic>
      </p:graphicFrame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A6E8A01-496B-6377-7CF7-CA6B8A70E4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7258277"/>
              </p:ext>
            </p:extLst>
          </p:nvPr>
        </p:nvGraphicFramePr>
        <p:xfrm>
          <a:off x="631285" y="2760892"/>
          <a:ext cx="11073284" cy="1776483"/>
        </p:xfrm>
        <a:graphic>
          <a:graphicData uri="http://schemas.openxmlformats.org/drawingml/2006/table">
            <a:tbl>
              <a:tblPr/>
              <a:tblGrid>
                <a:gridCol w="311499">
                  <a:extLst>
                    <a:ext uri="{9D8B030D-6E8A-4147-A177-3AD203B41FA5}">
                      <a16:colId xmlns:a16="http://schemas.microsoft.com/office/drawing/2014/main" val="3497076943"/>
                    </a:ext>
                  </a:extLst>
                </a:gridCol>
                <a:gridCol w="281354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1015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1075174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51692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221064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1191230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376313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1065125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21547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901982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444498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211253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1070436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326047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974690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341644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1045028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351693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holestero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249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UC (</a:t>
                      </a:r>
                      <a:r>
                        <a:rPr lang="el-G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4 (0.70 - 0.7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7 (0.70 - 0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(0.68-0.8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5(0.65-0.8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1 (0.66 - 0.7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0(0.64-0.7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2(0.62-0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9 (0.74 - 0.8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2 (0.75 - 0.8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7(0.66-0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8(0.77-0.9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5 (0.67 - 0.8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8(0.57-0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1(0.70-0.9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561079"/>
                  </a:ext>
                </a:extLst>
              </a:tr>
              <a:tr h="10543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 (0.73 - 0.8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9 (0.73 - 0.8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4(0.65-0.8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4(0.75-0.9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7 (0.70 - 0.8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3(0.59-0.8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0(0.71-0.8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470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3 (0.50 - 0.5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4 (0.50 - 0.5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(0.48-0.6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2(0.46-0.5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2 (0.48 - 0.5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1(0.46-0.5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2(0.45-0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3789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 (0.54 - 0.6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 (0.55 - 0.6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(0.47-0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5(0.56-0.7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7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5 (0.49 - 0.6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9(0.39-0.5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1(0.52-0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4853063"/>
                  </a:ext>
                </a:extLst>
              </a:tr>
              <a:tr h="13925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 (0.53 - 0.6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8 (0.53 - 0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4(0.45-0.6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2(0.55-0.7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7 (0.50 - 0.6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53(0.41-0.6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0(0.53-0.6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39912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 (0.20 - 0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 (0.20 - 0.2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(0.19-0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(0.19-0.2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 (0.18 - 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(0.17-0.2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(0.16-0.2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  <a:tr h="842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 (0.20 - 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2 (0.20 - 0.2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2(0.18-0.2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3(0.20-0.2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 (0.18 - 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(0.16-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(0.17-0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285483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 (0.20 - 0.2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 (0.20 - 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(0.18-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1(0.20-0.2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 (0.19 - 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(0.18-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0(0.18-0.2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713118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B48ADC2-8F37-2A83-F7D7-593085D809C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7270267"/>
              </p:ext>
            </p:extLst>
          </p:nvPr>
        </p:nvGraphicFramePr>
        <p:xfrm>
          <a:off x="631285" y="4741380"/>
          <a:ext cx="11286395" cy="1776483"/>
        </p:xfrm>
        <a:graphic>
          <a:graphicData uri="http://schemas.openxmlformats.org/drawingml/2006/table">
            <a:tbl>
              <a:tblPr/>
              <a:tblGrid>
                <a:gridCol w="311499">
                  <a:extLst>
                    <a:ext uri="{9D8B030D-6E8A-4147-A177-3AD203B41FA5}">
                      <a16:colId xmlns:a16="http://schemas.microsoft.com/office/drawing/2014/main" val="3497076943"/>
                    </a:ext>
                  </a:extLst>
                </a:gridCol>
                <a:gridCol w="281354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1015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1075174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446233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126523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1191230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376313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1065125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481849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1026160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121920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1076960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325120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1016000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386080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985520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416560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Lactic acid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gridSpan="2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700" b="1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24921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AUC (</a:t>
                      </a:r>
                      <a:r>
                        <a:rPr lang="el-G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2.56 (403.73 - 501.3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31.21 (373.10 - 489.3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37.31(346.37-528.2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25.11(327.62-522.5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5.84 (395.50 - 556.1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5.95(382.14-589.7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5.74(310.31-621.1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4.10 (520.05 - 648.1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2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56.51 (473.68 - 639.3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52.20(516.51-787.8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0.81(362.34-559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14.19 (514.86 - 713.5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53.89(619.36-888.4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1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74.50(347.66-601.3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1561079"/>
                  </a:ext>
                </a:extLst>
              </a:tr>
              <a:tr h="10543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66.36 (505.41 - 627.3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5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45.44 (466.53 - 624.3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30.89(515.07-746.7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0.00(346.00-574.0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9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9.17 (494.20 - 684.1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45.16(567.23-723.0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33.18(333.75-732.6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470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-12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09.28 (266.29 - 352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9.52 (240.78 - 338.2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00.86(223.32-378.4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78.18(198.17-358.1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0.85 (258.18 - 403.5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2.06(235.25-428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29.63(190.74-468.5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3789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27.69 (369.95 - 485.4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2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98.13 (324.79 - 471.4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2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87.18(368.94-605.4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09.08(223.06-395.0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59.93 (369.68 - 550.1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4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589.33(468.62-710.0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9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30.52(216.47-444.5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4853063"/>
                  </a:ext>
                </a:extLst>
              </a:tr>
              <a:tr h="13925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11.10 (355.45 - 466.7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6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90.85 (320.32 - 461.3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65.23(363.04-567.4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16.47(211.98-420.9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8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33.20 (345.09 - 521.3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491.90(415.42-568.3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8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374.50(193.20-555.8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399124"/>
                  </a:ext>
                </a:extLst>
              </a:tr>
              <a:tr h="164320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-2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3.27 (133.74 - 152.8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1.69 (128.68 - 154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6.45(116.74-156.1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6.93(125.04-168.8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5.00 (130.73 - 159.2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3.89(139.18-168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36.10(107.65-164.5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  <a:tr h="8429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6.41 (146.94 - 165.8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8.37 (146.27 - 170.4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5.02(144.16-185.8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3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1.73(134.46-169.0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4.27 (139.25 - 169.2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4.56(143.51-185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7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3.98(117.99-169.9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285483"/>
                  </a:ext>
                </a:extLst>
              </a:tr>
              <a:tr h="16432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5.25 (146.85 - 163.6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4.60 (142.68 - 166.5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65.67(146.83-184.5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06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43.53(126.60-160.4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5.97 (143.86 - 168.0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3.26(138.57-167.9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58.68(134.76-182.6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7131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699844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F68C49-38CB-2FCE-A881-288511E61B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091A94B-6005-59B3-F006-0E9A45BC748B}"/>
              </a:ext>
            </a:extLst>
          </p:cNvPr>
          <p:cNvSpPr txBox="1"/>
          <p:nvPr/>
        </p:nvSpPr>
        <p:spPr>
          <a:xfrm>
            <a:off x="90696" y="2502834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b)</a:t>
            </a:r>
            <a:endParaRPr lang="ja-JP" altLang="ja-JP" sz="14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E750D43-6793-5817-8E31-8FFFAEC40BAF}"/>
              </a:ext>
            </a:extLst>
          </p:cNvPr>
          <p:cNvSpPr txBox="1"/>
          <p:nvPr/>
        </p:nvSpPr>
        <p:spPr>
          <a:xfrm>
            <a:off x="226163" y="474409"/>
            <a:ext cx="12591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 S3</a:t>
            </a:r>
            <a:endParaRPr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8FE1ED3-0843-DFE5-E711-E6E7FA601033}"/>
              </a:ext>
            </a:extLst>
          </p:cNvPr>
          <p:cNvSpPr txBox="1"/>
          <p:nvPr/>
        </p:nvSpPr>
        <p:spPr>
          <a:xfrm>
            <a:off x="90696" y="912948"/>
            <a:ext cx="43204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/>
              <a:t>(a)</a:t>
            </a:r>
            <a:endParaRPr lang="ja-JP" altLang="ja-JP" sz="1400"/>
          </a:p>
        </p:txBody>
      </p:sp>
      <p:sp>
        <p:nvSpPr>
          <p:cNvPr id="20" name="コンテンツ プレースホルダー 2">
            <a:extLst>
              <a:ext uri="{FF2B5EF4-FFF2-40B4-BE49-F238E27FC236}">
                <a16:creationId xmlns:a16="http://schemas.microsoft.com/office/drawing/2014/main" id="{B0839E87-B325-C66B-6A1E-C00A8CC5E02C}"/>
              </a:ext>
            </a:extLst>
          </p:cNvPr>
          <p:cNvSpPr txBox="1">
            <a:spLocks/>
          </p:cNvSpPr>
          <p:nvPr/>
        </p:nvSpPr>
        <p:spPr>
          <a:xfrm>
            <a:off x="321276" y="5092483"/>
            <a:ext cx="11504140" cy="56511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3 Comparison of values of SC hydration and TEWL 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 0,14, and 28 days with CM </a:t>
            </a:r>
            <a:r>
              <a:rPr lang="en-US" altLang="ja-JP" sz="1600" b="1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c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J in the patients without and with AD</a:t>
            </a:r>
            <a:endParaRPr lang="ja-JP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コンテンツ プレースホルダー 2">
            <a:extLst>
              <a:ext uri="{FF2B5EF4-FFF2-40B4-BE49-F238E27FC236}">
                <a16:creationId xmlns:a16="http://schemas.microsoft.com/office/drawing/2014/main" id="{5B97C41F-31DF-3F97-E7F9-E11C14E13F65}"/>
              </a:ext>
            </a:extLst>
          </p:cNvPr>
          <p:cNvSpPr txBox="1">
            <a:spLocks/>
          </p:cNvSpPr>
          <p:nvPr/>
        </p:nvSpPr>
        <p:spPr>
          <a:xfrm>
            <a:off x="306720" y="5714134"/>
            <a:ext cx="11504140" cy="90833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0000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(a) SC hydration, (b) TEWL, mean and 95% CI were calculated with CM and PJ </a:t>
            </a:r>
            <a:r>
              <a:rPr lang="en-US" altLang="ja-JP" sz="1400" kern="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 patients with and without AD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were calculated by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lch’s t-test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0 vs 14 days and 0 vs 28 days. *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 </a:t>
            </a:r>
          </a:p>
          <a:p>
            <a:pPr marL="0" indent="0" algn="just">
              <a:lnSpc>
                <a:spcPct val="100000"/>
              </a:lnSpc>
              <a:spcBef>
                <a:spcPts val="0"/>
              </a:spcBef>
              <a:buNone/>
            </a:pP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, atopic dermatitis; CI, confidence interval; CM, cream-type moisturizer; PJ, petroleum jelly; SC, stratum corneum; TEWL, </a:t>
            </a:r>
            <a:r>
              <a:rPr lang="en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epidermal</a:t>
            </a: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ter loss.</a:t>
            </a:r>
          </a:p>
          <a:p>
            <a:pPr marL="0" indent="0" algn="just">
              <a:lnSpc>
                <a:spcPct val="100000"/>
              </a:lnSpc>
              <a:buNone/>
            </a:pP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12BF9311-7049-43D2-84CA-F730E4F4EE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07391"/>
              </p:ext>
            </p:extLst>
          </p:nvPr>
        </p:nvGraphicFramePr>
        <p:xfrm>
          <a:off x="434762" y="1143866"/>
          <a:ext cx="10304083" cy="1073521"/>
        </p:xfrm>
        <a:graphic>
          <a:graphicData uri="http://schemas.openxmlformats.org/drawingml/2006/table">
            <a:tbl>
              <a:tblPr/>
              <a:tblGrid>
                <a:gridCol w="506207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5183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915061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81461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211922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847691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434441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858286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60268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890075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509072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158484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794709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423846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985439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445037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985440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381461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</a:rPr>
                        <a:t>SC hydration</a:t>
                      </a:r>
                    </a:p>
                  </a:txBody>
                  <a:tcPr marL="5535" marR="5535" marT="553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fontAlgn="ctr"/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游ゴシック" panose="020B0400000000000000" pitchFamily="34" charset="-128"/>
                      </a:endParaRP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1804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Days</a:t>
                      </a:r>
                    </a:p>
                  </a:txBody>
                  <a:tcPr marL="5535" marR="5535" marT="5535" marB="0" anchor="ctr">
                    <a:lnL w="12700" cmpd="sng">
                      <a:noFill/>
                      <a:prstDash val="soli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0</a:t>
                      </a:r>
                    </a:p>
                  </a:txBody>
                  <a:tcPr marL="5535" marR="5535" marT="5535" marB="0" anchor="ctr">
                    <a:lnL w="12700" cmpd="sng">
                      <a:noFill/>
                      <a:prstDash val="soli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7.97 (34.91 - 41.0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8.6 (33.8 - 43.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9.31(31.89-46.7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7.83(29.96-45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7.3 (33.4 - 41.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5.94(30.18-41.70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38.71(31.80-45.6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-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14</a:t>
                      </a:r>
                    </a:p>
                  </a:txBody>
                  <a:tcPr marL="5535" marR="5535" marT="553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3.19 (49.83 - 56.5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6.2 (51.6 - 60.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61.2(54.42-67.9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1.18(44.50-57.8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49.9 (45.3 - 54.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5.84(48.88-62.7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&lt;0.001</a:t>
                      </a: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44(38.31-49.6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0.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1643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游ゴシック" panose="020B0400000000000000" pitchFamily="34" charset="-128"/>
                        </a:rPr>
                        <a:t>28</a:t>
                      </a:r>
                    </a:p>
                  </a:txBody>
                  <a:tcPr marL="5535" marR="5535" marT="5535" marB="0" anchor="ctr">
                    <a:lnL w="12700" cmpd="sng">
                      <a:noFill/>
                      <a:prstDash val="soli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2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3.05 (49.66 - 56.4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3.3 (49.1 - 57.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8.37(52.31-64.4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48.21(42.54-53.87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0.003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2.8 (47.2 - 58.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lt;0.001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56.93(47.89-65.9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</a:rPr>
                        <a:t>&lt;0.001</a:t>
                      </a: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48.67(40.32-57.0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</a:rPr>
                        <a:t>0.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</a:tbl>
          </a:graphicData>
        </a:graphic>
      </p:graphicFrame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36FF3A27-83EF-9732-967E-D4A402C0F8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158763"/>
              </p:ext>
            </p:extLst>
          </p:nvPr>
        </p:nvGraphicFramePr>
        <p:xfrm>
          <a:off x="434762" y="2674448"/>
          <a:ext cx="10304084" cy="891441"/>
        </p:xfrm>
        <a:graphic>
          <a:graphicData uri="http://schemas.openxmlformats.org/drawingml/2006/table">
            <a:tbl>
              <a:tblPr/>
              <a:tblGrid>
                <a:gridCol w="428561">
                  <a:extLst>
                    <a:ext uri="{9D8B030D-6E8A-4147-A177-3AD203B41FA5}">
                      <a16:colId xmlns:a16="http://schemas.microsoft.com/office/drawing/2014/main" val="4221662315"/>
                    </a:ext>
                  </a:extLst>
                </a:gridCol>
                <a:gridCol w="216888">
                  <a:extLst>
                    <a:ext uri="{9D8B030D-6E8A-4147-A177-3AD203B41FA5}">
                      <a16:colId xmlns:a16="http://schemas.microsoft.com/office/drawing/2014/main" val="1308675808"/>
                    </a:ext>
                  </a:extLst>
                </a:gridCol>
                <a:gridCol w="1009961">
                  <a:extLst>
                    <a:ext uri="{9D8B030D-6E8A-4147-A177-3AD203B41FA5}">
                      <a16:colId xmlns:a16="http://schemas.microsoft.com/office/drawing/2014/main" val="1743515077"/>
                    </a:ext>
                  </a:extLst>
                </a:gridCol>
                <a:gridCol w="386864">
                  <a:extLst>
                    <a:ext uri="{9D8B030D-6E8A-4147-A177-3AD203B41FA5}">
                      <a16:colId xmlns:a16="http://schemas.microsoft.com/office/drawing/2014/main" val="2913640349"/>
                    </a:ext>
                  </a:extLst>
                </a:gridCol>
                <a:gridCol w="204810">
                  <a:extLst>
                    <a:ext uri="{9D8B030D-6E8A-4147-A177-3AD203B41FA5}">
                      <a16:colId xmlns:a16="http://schemas.microsoft.com/office/drawing/2014/main" val="2188193622"/>
                    </a:ext>
                  </a:extLst>
                </a:gridCol>
                <a:gridCol w="819241">
                  <a:extLst>
                    <a:ext uri="{9D8B030D-6E8A-4147-A177-3AD203B41FA5}">
                      <a16:colId xmlns:a16="http://schemas.microsoft.com/office/drawing/2014/main" val="2227936711"/>
                    </a:ext>
                  </a:extLst>
                </a:gridCol>
                <a:gridCol w="391815">
                  <a:extLst>
                    <a:ext uri="{9D8B030D-6E8A-4147-A177-3AD203B41FA5}">
                      <a16:colId xmlns:a16="http://schemas.microsoft.com/office/drawing/2014/main" val="670900774"/>
                    </a:ext>
                  </a:extLst>
                </a:gridCol>
                <a:gridCol w="1007722">
                  <a:extLst>
                    <a:ext uri="{9D8B030D-6E8A-4147-A177-3AD203B41FA5}">
                      <a16:colId xmlns:a16="http://schemas.microsoft.com/office/drawing/2014/main" val="606614723"/>
                    </a:ext>
                  </a:extLst>
                </a:gridCol>
                <a:gridCol w="364108">
                  <a:extLst>
                    <a:ext uri="{9D8B030D-6E8A-4147-A177-3AD203B41FA5}">
                      <a16:colId xmlns:a16="http://schemas.microsoft.com/office/drawing/2014/main" val="847850706"/>
                    </a:ext>
                  </a:extLst>
                </a:gridCol>
                <a:gridCol w="887511">
                  <a:extLst>
                    <a:ext uri="{9D8B030D-6E8A-4147-A177-3AD203B41FA5}">
                      <a16:colId xmlns:a16="http://schemas.microsoft.com/office/drawing/2014/main" val="2117661637"/>
                    </a:ext>
                  </a:extLst>
                </a:gridCol>
                <a:gridCol w="417239">
                  <a:extLst>
                    <a:ext uri="{9D8B030D-6E8A-4147-A177-3AD203B41FA5}">
                      <a16:colId xmlns:a16="http://schemas.microsoft.com/office/drawing/2014/main" val="2330914373"/>
                    </a:ext>
                  </a:extLst>
                </a:gridCol>
                <a:gridCol w="197078">
                  <a:extLst>
                    <a:ext uri="{9D8B030D-6E8A-4147-A177-3AD203B41FA5}">
                      <a16:colId xmlns:a16="http://schemas.microsoft.com/office/drawing/2014/main" val="3777304380"/>
                    </a:ext>
                  </a:extLst>
                </a:gridCol>
                <a:gridCol w="887625">
                  <a:extLst>
                    <a:ext uri="{9D8B030D-6E8A-4147-A177-3AD203B41FA5}">
                      <a16:colId xmlns:a16="http://schemas.microsoft.com/office/drawing/2014/main" val="3222400666"/>
                    </a:ext>
                  </a:extLst>
                </a:gridCol>
                <a:gridCol w="420999">
                  <a:extLst>
                    <a:ext uri="{9D8B030D-6E8A-4147-A177-3AD203B41FA5}">
                      <a16:colId xmlns:a16="http://schemas.microsoft.com/office/drawing/2014/main" val="1053346624"/>
                    </a:ext>
                  </a:extLst>
                </a:gridCol>
                <a:gridCol w="1021417">
                  <a:extLst>
                    <a:ext uri="{9D8B030D-6E8A-4147-A177-3AD203B41FA5}">
                      <a16:colId xmlns:a16="http://schemas.microsoft.com/office/drawing/2014/main" val="727725599"/>
                    </a:ext>
                  </a:extLst>
                </a:gridCol>
                <a:gridCol w="384283">
                  <a:extLst>
                    <a:ext uri="{9D8B030D-6E8A-4147-A177-3AD203B41FA5}">
                      <a16:colId xmlns:a16="http://schemas.microsoft.com/office/drawing/2014/main" val="3749415303"/>
                    </a:ext>
                  </a:extLst>
                </a:gridCol>
                <a:gridCol w="904775">
                  <a:extLst>
                    <a:ext uri="{9D8B030D-6E8A-4147-A177-3AD203B41FA5}">
                      <a16:colId xmlns:a16="http://schemas.microsoft.com/office/drawing/2014/main" val="1590169287"/>
                    </a:ext>
                  </a:extLst>
                </a:gridCol>
                <a:gridCol w="353187">
                  <a:extLst>
                    <a:ext uri="{9D8B030D-6E8A-4147-A177-3AD203B41FA5}">
                      <a16:colId xmlns:a16="http://schemas.microsoft.com/office/drawing/2014/main" val="1617080873"/>
                    </a:ext>
                  </a:extLst>
                </a:gridCol>
              </a:tblGrid>
              <a:tr h="127373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ja-JP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TEWL</a:t>
                      </a:r>
                    </a:p>
                  </a:txBody>
                  <a:tcPr marL="5535" marR="5535" marT="5535" marB="0" anchor="ctr">
                    <a:lnL w="12700" cmpd="sng">
                      <a:noFill/>
                      <a:prstDash val="soli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gridSpan="3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Non-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AD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3907904"/>
                  </a:ext>
                </a:extLst>
              </a:tr>
              <a:tr h="12737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　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Total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CM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J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7225843"/>
                  </a:ext>
                </a:extLst>
              </a:tr>
              <a:tr h="18043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Days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n</a:t>
                      </a:r>
                    </a:p>
                  </a:txBody>
                  <a:tcPr marL="5535" marR="5535" marT="55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Mean (95% CI)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p-value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982395"/>
                  </a:ext>
                </a:extLst>
              </a:tr>
              <a:tr h="127373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77 (12.34 - 15.19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4 (12.2 - 16.6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.02(10.28-19.7</a:t>
                      </a:r>
                      <a:r>
                        <a:rPr lang="ja-JP" altLang="en-U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７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68(12.05-15.31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1 (11.4 - 14.9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.49(11.16-13.81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78(9.91-17.64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048210"/>
                  </a:ext>
                </a:extLst>
              </a:tr>
              <a:tr h="1643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14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29 (12.33 - 14.24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8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4 (11.7 - 15.1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0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.3</a:t>
                      </a:r>
                      <a:r>
                        <a:rPr lang="ja-JP" altLang="en-U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４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9.50-15.17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55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44(11.85-17.03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5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2 (12.5 - 13.9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26(12.04-14.48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70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09(11.94-14.23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4613471"/>
                  </a:ext>
                </a:extLst>
              </a:tr>
              <a:tr h="1643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34" charset="-128"/>
                          <a:cs typeface="Calibri" panose="020F0502020204030204" pitchFamily="34" charset="0"/>
                        </a:rPr>
                        <a:t>28</a:t>
                      </a:r>
                    </a:p>
                  </a:txBody>
                  <a:tcPr marL="5535" marR="5535" marT="5535" marB="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3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56 (12.97 - 16.16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7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5 (11.7 - 17.2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5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.35(11.78-14.93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9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.59(9.60-21.59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&gt;0.99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1</a:t>
                      </a:r>
                    </a:p>
                  </a:txBody>
                  <a:tcPr marL="47625" marR="47625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7 (13.1 - 16.2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21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4.18(12.56-15.80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0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5.14(11.95-18.33)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97</a:t>
                      </a:r>
                    </a:p>
                  </a:txBody>
                  <a:tcPr marL="47625" marR="47625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60894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120885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6" name="グループ化 205">
            <a:extLst>
              <a:ext uri="{FF2B5EF4-FFF2-40B4-BE49-F238E27FC236}">
                <a16:creationId xmlns:a16="http://schemas.microsoft.com/office/drawing/2014/main" id="{21B5950A-7616-5A1D-DCC1-4C8AA2D63CFA}"/>
              </a:ext>
            </a:extLst>
          </p:cNvPr>
          <p:cNvGrpSpPr/>
          <p:nvPr/>
        </p:nvGrpSpPr>
        <p:grpSpPr>
          <a:xfrm>
            <a:off x="7512596" y="1794687"/>
            <a:ext cx="3210437" cy="329292"/>
            <a:chOff x="1591821" y="1209599"/>
            <a:chExt cx="3210437" cy="329292"/>
          </a:xfrm>
        </p:grpSpPr>
        <p:sp>
          <p:nvSpPr>
            <p:cNvPr id="207" name="タイトル 15">
              <a:extLst>
                <a:ext uri="{FF2B5EF4-FFF2-40B4-BE49-F238E27FC236}">
                  <a16:creationId xmlns:a16="http://schemas.microsoft.com/office/drawing/2014/main" id="{8295CC31-B11B-F85B-FCAC-8179D2E954B7}"/>
                </a:ext>
              </a:extLst>
            </p:cNvPr>
            <p:cNvSpPr txBox="1">
              <a:spLocks/>
            </p:cNvSpPr>
            <p:nvPr/>
          </p:nvSpPr>
          <p:spPr>
            <a:xfrm>
              <a:off x="1591821" y="1209599"/>
              <a:ext cx="3210437" cy="262669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lIns="91440" tIns="45720" rIns="91440" bIns="45720" rtlCol="0" anchor="ctr">
              <a:normAutofit fontScale="92500" lnSpcReduction="10000"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8" name="グループ化 207">
              <a:extLst>
                <a:ext uri="{FF2B5EF4-FFF2-40B4-BE49-F238E27FC236}">
                  <a16:creationId xmlns:a16="http://schemas.microsoft.com/office/drawing/2014/main" id="{DE2D9BEB-1F45-307E-801B-AF2F45BB1AFE}"/>
                </a:ext>
              </a:extLst>
            </p:cNvPr>
            <p:cNvGrpSpPr/>
            <p:nvPr/>
          </p:nvGrpSpPr>
          <p:grpSpPr>
            <a:xfrm>
              <a:off x="1831214" y="1216159"/>
              <a:ext cx="2836785" cy="322732"/>
              <a:chOff x="1473864" y="440894"/>
              <a:chExt cx="2004961" cy="223780"/>
            </a:xfrm>
            <a:noFill/>
          </p:grpSpPr>
          <p:sp>
            <p:nvSpPr>
              <p:cNvPr id="209" name="タイトル 15">
                <a:extLst>
                  <a:ext uri="{FF2B5EF4-FFF2-40B4-BE49-F238E27FC236}">
                    <a16:creationId xmlns:a16="http://schemas.microsoft.com/office/drawing/2014/main" id="{6CCD672D-B0F0-8A9F-4CDB-1B25535A7AB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473864" y="440894"/>
                <a:ext cx="545961" cy="220250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AD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タイトル 15">
                <a:extLst>
                  <a:ext uri="{FF2B5EF4-FFF2-40B4-BE49-F238E27FC236}">
                    <a16:creationId xmlns:a16="http://schemas.microsoft.com/office/drawing/2014/main" id="{A56C6294-9634-9BF1-72C5-EB24CEC654D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48334" y="444424"/>
                <a:ext cx="330491" cy="220250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233" name="図 232">
            <a:extLst>
              <a:ext uri="{FF2B5EF4-FFF2-40B4-BE49-F238E27FC236}">
                <a16:creationId xmlns:a16="http://schemas.microsoft.com/office/drawing/2014/main" id="{CCEFB395-FA24-560C-3774-18FB8CDFEF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0556" y="2047337"/>
            <a:ext cx="4529415" cy="2187177"/>
          </a:xfrm>
          <a:prstGeom prst="rect">
            <a:avLst/>
          </a:prstGeom>
        </p:spPr>
      </p:pic>
      <p:sp>
        <p:nvSpPr>
          <p:cNvPr id="235" name="正方形/長方形 234">
            <a:extLst>
              <a:ext uri="{FF2B5EF4-FFF2-40B4-BE49-F238E27FC236}">
                <a16:creationId xmlns:a16="http://schemas.microsoft.com/office/drawing/2014/main" id="{4B54A452-E110-49B2-7896-8F93F18A9087}"/>
              </a:ext>
            </a:extLst>
          </p:cNvPr>
          <p:cNvSpPr/>
          <p:nvPr/>
        </p:nvSpPr>
        <p:spPr>
          <a:xfrm>
            <a:off x="7221466" y="4227785"/>
            <a:ext cx="4001807" cy="2620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12" name="グループ化 211">
            <a:extLst>
              <a:ext uri="{FF2B5EF4-FFF2-40B4-BE49-F238E27FC236}">
                <a16:creationId xmlns:a16="http://schemas.microsoft.com/office/drawing/2014/main" id="{A0F77591-36FF-CF08-C89D-88FFC20E27DC}"/>
              </a:ext>
            </a:extLst>
          </p:cNvPr>
          <p:cNvGrpSpPr/>
          <p:nvPr/>
        </p:nvGrpSpPr>
        <p:grpSpPr>
          <a:xfrm>
            <a:off x="6476553" y="2175511"/>
            <a:ext cx="4774470" cy="2232200"/>
            <a:chOff x="555778" y="1590428"/>
            <a:chExt cx="4774470" cy="2232200"/>
          </a:xfrm>
        </p:grpSpPr>
        <p:sp>
          <p:nvSpPr>
            <p:cNvPr id="213" name="タイトル 15">
              <a:extLst>
                <a:ext uri="{FF2B5EF4-FFF2-40B4-BE49-F238E27FC236}">
                  <a16:creationId xmlns:a16="http://schemas.microsoft.com/office/drawing/2014/main" id="{63ACB5AB-B32A-F7DB-1F6B-5BFF0C162827}"/>
                </a:ext>
              </a:extLst>
            </p:cNvPr>
            <p:cNvSpPr txBox="1">
              <a:spLocks/>
            </p:cNvSpPr>
            <p:nvPr/>
          </p:nvSpPr>
          <p:spPr>
            <a:xfrm>
              <a:off x="555778" y="1923816"/>
              <a:ext cx="278113" cy="125832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lIns="90000" tIns="45720" rIns="91440" bIns="45720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TEWL (g/h/m2.μm) </a:t>
              </a:r>
            </a:p>
          </p:txBody>
        </p:sp>
        <p:grpSp>
          <p:nvGrpSpPr>
            <p:cNvPr id="214" name="グループ化 213">
              <a:extLst>
                <a:ext uri="{FF2B5EF4-FFF2-40B4-BE49-F238E27FC236}">
                  <a16:creationId xmlns:a16="http://schemas.microsoft.com/office/drawing/2014/main" id="{C2A3DC51-81AF-E324-E5B2-0A33F8A18093}"/>
                </a:ext>
              </a:extLst>
            </p:cNvPr>
            <p:cNvGrpSpPr/>
            <p:nvPr/>
          </p:nvGrpSpPr>
          <p:grpSpPr>
            <a:xfrm>
              <a:off x="819305" y="1590428"/>
              <a:ext cx="360484" cy="2103333"/>
              <a:chOff x="819305" y="1590428"/>
              <a:chExt cx="360484" cy="2103333"/>
            </a:xfrm>
          </p:grpSpPr>
          <p:sp>
            <p:nvSpPr>
              <p:cNvPr id="226" name="タイトル 15">
                <a:extLst>
                  <a:ext uri="{FF2B5EF4-FFF2-40B4-BE49-F238E27FC236}">
                    <a16:creationId xmlns:a16="http://schemas.microsoft.com/office/drawing/2014/main" id="{9C9AA3AC-D563-FC3A-D3F4-08A923572D32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7646" y="2995866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タイトル 15">
                <a:extLst>
                  <a:ext uri="{FF2B5EF4-FFF2-40B4-BE49-F238E27FC236}">
                    <a16:creationId xmlns:a16="http://schemas.microsoft.com/office/drawing/2014/main" id="{3A1886E0-57AF-1CE5-6221-DCBB6FE8BAB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19305" y="3467896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9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タイトル 15">
                <a:extLst>
                  <a:ext uri="{FF2B5EF4-FFF2-40B4-BE49-F238E27FC236}">
                    <a16:creationId xmlns:a16="http://schemas.microsoft.com/office/drawing/2014/main" id="{8473ADD5-4818-DD79-5D6C-B795D7B1F31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5239" y="1590428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タイトル 15">
                <a:extLst>
                  <a:ext uri="{FF2B5EF4-FFF2-40B4-BE49-F238E27FC236}">
                    <a16:creationId xmlns:a16="http://schemas.microsoft.com/office/drawing/2014/main" id="{BD456332-C602-CDEE-F5A1-1993C85D7814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30463" y="2055478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タイトル 15">
                <a:extLst>
                  <a:ext uri="{FF2B5EF4-FFF2-40B4-BE49-F238E27FC236}">
                    <a16:creationId xmlns:a16="http://schemas.microsoft.com/office/drawing/2014/main" id="{B77B7E48-DE50-4DA9-F8A1-33B46995827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8561" y="2528034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6" name="グループ化 215">
              <a:extLst>
                <a:ext uri="{FF2B5EF4-FFF2-40B4-BE49-F238E27FC236}">
                  <a16:creationId xmlns:a16="http://schemas.microsoft.com/office/drawing/2014/main" id="{B147336C-BB0A-65B5-B22A-F3CA7906A90E}"/>
                </a:ext>
              </a:extLst>
            </p:cNvPr>
            <p:cNvGrpSpPr/>
            <p:nvPr/>
          </p:nvGrpSpPr>
          <p:grpSpPr>
            <a:xfrm>
              <a:off x="1362598" y="3598950"/>
              <a:ext cx="3967650" cy="223678"/>
              <a:chOff x="1362598" y="3598950"/>
              <a:chExt cx="3967650" cy="223678"/>
            </a:xfrm>
          </p:grpSpPr>
          <p:grpSp>
            <p:nvGrpSpPr>
              <p:cNvPr id="218" name="グループ化 217">
                <a:extLst>
                  <a:ext uri="{FF2B5EF4-FFF2-40B4-BE49-F238E27FC236}">
                    <a16:creationId xmlns:a16="http://schemas.microsoft.com/office/drawing/2014/main" id="{EA7125F1-B7BF-3541-88DB-E60269FDE2DD}"/>
                  </a:ext>
                </a:extLst>
              </p:cNvPr>
              <p:cNvGrpSpPr/>
              <p:nvPr/>
            </p:nvGrpSpPr>
            <p:grpSpPr>
              <a:xfrm>
                <a:off x="3589853" y="3598950"/>
                <a:ext cx="1740395" cy="220250"/>
                <a:chOff x="7316319" y="6547266"/>
                <a:chExt cx="1740395" cy="220250"/>
              </a:xfrm>
            </p:grpSpPr>
            <p:sp>
              <p:nvSpPr>
                <p:cNvPr id="223" name="タイトル 15">
                  <a:extLst>
                    <a:ext uri="{FF2B5EF4-FFF2-40B4-BE49-F238E27FC236}">
                      <a16:creationId xmlns:a16="http://schemas.microsoft.com/office/drawing/2014/main" id="{DE8F24AC-C767-E884-5196-FA9DF2D787C9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316319" y="6547266"/>
                  <a:ext cx="190400" cy="22025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4" name="タイトル 15">
                  <a:extLst>
                    <a:ext uri="{FF2B5EF4-FFF2-40B4-BE49-F238E27FC236}">
                      <a16:creationId xmlns:a16="http://schemas.microsoft.com/office/drawing/2014/main" id="{87BD2A1C-700F-4358-39CC-D7B95A044DF8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979516" y="6547266"/>
                  <a:ext cx="316115" cy="2071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5" name="タイトル 15">
                  <a:extLst>
                    <a:ext uri="{FF2B5EF4-FFF2-40B4-BE49-F238E27FC236}">
                      <a16:creationId xmlns:a16="http://schemas.microsoft.com/office/drawing/2014/main" id="{94F6A6AF-F5BC-3E36-34A6-9C00CB7A5DEE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8662245" y="6548237"/>
                  <a:ext cx="394469" cy="21927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8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B6003946-692C-132E-5732-8FDAEF499D18}"/>
                  </a:ext>
                </a:extLst>
              </p:cNvPr>
              <p:cNvGrpSpPr/>
              <p:nvPr/>
            </p:nvGrpSpPr>
            <p:grpSpPr>
              <a:xfrm>
                <a:off x="1362598" y="3599921"/>
                <a:ext cx="1731308" cy="222707"/>
                <a:chOff x="5100787" y="6548237"/>
                <a:chExt cx="1731308" cy="222707"/>
              </a:xfrm>
            </p:grpSpPr>
            <p:sp>
              <p:nvSpPr>
                <p:cNvPr id="220" name="タイトル 15">
                  <a:extLst>
                    <a:ext uri="{FF2B5EF4-FFF2-40B4-BE49-F238E27FC236}">
                      <a16:creationId xmlns:a16="http://schemas.microsoft.com/office/drawing/2014/main" id="{4FBFB360-4816-87FD-6EDD-5074EA8E0409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100787" y="6550694"/>
                  <a:ext cx="190400" cy="22025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タイトル 15">
                  <a:extLst>
                    <a:ext uri="{FF2B5EF4-FFF2-40B4-BE49-F238E27FC236}">
                      <a16:creationId xmlns:a16="http://schemas.microsoft.com/office/drawing/2014/main" id="{8B5DA63B-ECB4-ADA1-C492-A69F1F7E1851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753574" y="6553932"/>
                  <a:ext cx="334155" cy="20050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タイトル 15">
                  <a:extLst>
                    <a:ext uri="{FF2B5EF4-FFF2-40B4-BE49-F238E27FC236}">
                      <a16:creationId xmlns:a16="http://schemas.microsoft.com/office/drawing/2014/main" id="{C4A3E26B-40F0-23D3-D103-2C5EEABC86EC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6437626" y="6548237"/>
                  <a:ext cx="394469" cy="21927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8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7" name="テキスト プレースホルダー 16">
            <a:extLst>
              <a:ext uri="{FF2B5EF4-FFF2-40B4-BE49-F238E27FC236}">
                <a16:creationId xmlns:a16="http://schemas.microsoft.com/office/drawing/2014/main" id="{A398BFB9-6A7C-331E-D73D-3D8B430754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14844" y="1466835"/>
            <a:ext cx="481832" cy="408782"/>
          </a:xfrm>
        </p:spPr>
        <p:txBody>
          <a:bodyPr>
            <a:normAutofit/>
          </a:bodyPr>
          <a:lstStyle/>
          <a:p>
            <a:r>
              <a:rPr lang="en-US" altLang="ja-JP" sz="1600" b="0" dirty="0"/>
              <a:t>(a)</a:t>
            </a:r>
            <a:endParaRPr lang="ja-JP" altLang="en-US" sz="1600" b="0"/>
          </a:p>
        </p:txBody>
      </p: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id="{499CE0FC-510E-CD7E-1898-83003451F229}"/>
              </a:ext>
            </a:extLst>
          </p:cNvPr>
          <p:cNvGrpSpPr/>
          <p:nvPr/>
        </p:nvGrpSpPr>
        <p:grpSpPr>
          <a:xfrm>
            <a:off x="1591821" y="1794687"/>
            <a:ext cx="3210437" cy="329292"/>
            <a:chOff x="1591821" y="1209599"/>
            <a:chExt cx="3210437" cy="329292"/>
          </a:xfrm>
        </p:grpSpPr>
        <p:sp>
          <p:nvSpPr>
            <p:cNvPr id="45" name="タイトル 15">
              <a:extLst>
                <a:ext uri="{FF2B5EF4-FFF2-40B4-BE49-F238E27FC236}">
                  <a16:creationId xmlns:a16="http://schemas.microsoft.com/office/drawing/2014/main" id="{4E74C6B3-BF80-42CF-E92F-4C265CBBB474}"/>
                </a:ext>
              </a:extLst>
            </p:cNvPr>
            <p:cNvSpPr txBox="1">
              <a:spLocks/>
            </p:cNvSpPr>
            <p:nvPr/>
          </p:nvSpPr>
          <p:spPr>
            <a:xfrm>
              <a:off x="1591821" y="1209599"/>
              <a:ext cx="3210437" cy="262669"/>
            </a:xfrm>
            <a:prstGeom prst="rect">
              <a:avLst/>
            </a:prstGeom>
            <a:solidFill>
              <a:schemeClr val="bg1"/>
            </a:solidFill>
          </p:spPr>
          <p:txBody>
            <a:bodyPr vert="horz" lIns="91440" tIns="45720" rIns="91440" bIns="45720" rtlCol="0" anchor="ctr">
              <a:normAutofit fontScale="92500" lnSpcReduction="10000"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endParaRPr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4ECF8FF7-B061-4B69-3CE4-66F2E30A38CE}"/>
                </a:ext>
              </a:extLst>
            </p:cNvPr>
            <p:cNvGrpSpPr/>
            <p:nvPr/>
          </p:nvGrpSpPr>
          <p:grpSpPr>
            <a:xfrm>
              <a:off x="1831214" y="1216159"/>
              <a:ext cx="2836785" cy="322732"/>
              <a:chOff x="1473864" y="440894"/>
              <a:chExt cx="2004961" cy="223780"/>
            </a:xfrm>
            <a:noFill/>
          </p:grpSpPr>
          <p:sp>
            <p:nvSpPr>
              <p:cNvPr id="47" name="タイトル 15">
                <a:extLst>
                  <a:ext uri="{FF2B5EF4-FFF2-40B4-BE49-F238E27FC236}">
                    <a16:creationId xmlns:a16="http://schemas.microsoft.com/office/drawing/2014/main" id="{A476D159-A7B2-7FF6-96CC-EB6CC84DAA5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473864" y="440894"/>
                <a:ext cx="545961" cy="220250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AD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タイトル 15">
                <a:extLst>
                  <a:ext uri="{FF2B5EF4-FFF2-40B4-BE49-F238E27FC236}">
                    <a16:creationId xmlns:a16="http://schemas.microsoft.com/office/drawing/2014/main" id="{E2C416B9-4748-956A-48C0-7F953C8C39D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48334" y="444424"/>
                <a:ext cx="330491" cy="220250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D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8" name="タイトル 15">
            <a:extLst>
              <a:ext uri="{FF2B5EF4-FFF2-40B4-BE49-F238E27FC236}">
                <a16:creationId xmlns:a16="http://schemas.microsoft.com/office/drawing/2014/main" id="{8D2E4267-5B94-4C96-B1D9-96669CD2C423}"/>
              </a:ext>
            </a:extLst>
          </p:cNvPr>
          <p:cNvSpPr txBox="1">
            <a:spLocks/>
          </p:cNvSpPr>
          <p:nvPr/>
        </p:nvSpPr>
        <p:spPr>
          <a:xfrm>
            <a:off x="1397401" y="257809"/>
            <a:ext cx="229251" cy="1466468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タイトル 15">
            <a:extLst>
              <a:ext uri="{FF2B5EF4-FFF2-40B4-BE49-F238E27FC236}">
                <a16:creationId xmlns:a16="http://schemas.microsoft.com/office/drawing/2014/main" id="{076D2526-A82D-C363-03E9-418AAF9A0B8C}"/>
              </a:ext>
            </a:extLst>
          </p:cNvPr>
          <p:cNvSpPr txBox="1">
            <a:spLocks/>
          </p:cNvSpPr>
          <p:nvPr/>
        </p:nvSpPr>
        <p:spPr>
          <a:xfrm>
            <a:off x="1270948" y="180739"/>
            <a:ext cx="124899" cy="1939156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A5DA457A-CDC3-777D-907A-F58985F43997}"/>
              </a:ext>
            </a:extLst>
          </p:cNvPr>
          <p:cNvGrpSpPr/>
          <p:nvPr/>
        </p:nvGrpSpPr>
        <p:grpSpPr>
          <a:xfrm>
            <a:off x="5489073" y="2814499"/>
            <a:ext cx="829866" cy="594049"/>
            <a:chOff x="5471981" y="2131576"/>
            <a:chExt cx="829866" cy="594049"/>
          </a:xfrm>
        </p:grpSpPr>
        <p:pic>
          <p:nvPicPr>
            <p:cNvPr id="96" name="図 95">
              <a:extLst>
                <a:ext uri="{FF2B5EF4-FFF2-40B4-BE49-F238E27FC236}">
                  <a16:creationId xmlns:a16="http://schemas.microsoft.com/office/drawing/2014/main" id="{DE616457-5F39-559C-4BF0-529D5E8DDB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71981" y="2151306"/>
              <a:ext cx="305686" cy="574319"/>
            </a:xfrm>
            <a:prstGeom prst="rect">
              <a:avLst/>
            </a:prstGeom>
          </p:spPr>
        </p:pic>
        <p:grpSp>
          <p:nvGrpSpPr>
            <p:cNvPr id="166" name="グループ化 165">
              <a:extLst>
                <a:ext uri="{FF2B5EF4-FFF2-40B4-BE49-F238E27FC236}">
                  <a16:creationId xmlns:a16="http://schemas.microsoft.com/office/drawing/2014/main" id="{82178704-E520-7114-75C8-AFFDE54A4F38}"/>
                </a:ext>
              </a:extLst>
            </p:cNvPr>
            <p:cNvGrpSpPr/>
            <p:nvPr/>
          </p:nvGrpSpPr>
          <p:grpSpPr>
            <a:xfrm>
              <a:off x="5680067" y="2131576"/>
              <a:ext cx="621780" cy="556007"/>
              <a:chOff x="5783234" y="1192888"/>
              <a:chExt cx="621780" cy="556007"/>
            </a:xfrm>
          </p:grpSpPr>
          <p:sp>
            <p:nvSpPr>
              <p:cNvPr id="146" name="タイトル 15">
                <a:extLst>
                  <a:ext uri="{FF2B5EF4-FFF2-40B4-BE49-F238E27FC236}">
                    <a16:creationId xmlns:a16="http://schemas.microsoft.com/office/drawing/2014/main" id="{C5E143A2-303D-4F60-5822-E04E71B955F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783234" y="1192888"/>
                <a:ext cx="621780" cy="31764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M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タイトル 15">
                <a:extLst>
                  <a:ext uri="{FF2B5EF4-FFF2-40B4-BE49-F238E27FC236}">
                    <a16:creationId xmlns:a16="http://schemas.microsoft.com/office/drawing/2014/main" id="{67E0ABC5-D673-657C-DDD7-A08C6966A91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809478" y="1431254"/>
                <a:ext cx="493062" cy="31764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J</a:t>
                </a:r>
                <a:endParaRPr lang="ja-JP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97" name="タイトル 15">
            <a:extLst>
              <a:ext uri="{FF2B5EF4-FFF2-40B4-BE49-F238E27FC236}">
                <a16:creationId xmlns:a16="http://schemas.microsoft.com/office/drawing/2014/main" id="{5C59879A-AEE9-688E-E68C-BF8E566ADCA9}"/>
              </a:ext>
            </a:extLst>
          </p:cNvPr>
          <p:cNvSpPr txBox="1">
            <a:spLocks/>
          </p:cNvSpPr>
          <p:nvPr/>
        </p:nvSpPr>
        <p:spPr>
          <a:xfrm>
            <a:off x="436688" y="758574"/>
            <a:ext cx="1212151" cy="4497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8" name="図 187">
            <a:extLst>
              <a:ext uri="{FF2B5EF4-FFF2-40B4-BE49-F238E27FC236}">
                <a16:creationId xmlns:a16="http://schemas.microsoft.com/office/drawing/2014/main" id="{663383BF-052C-17B9-D368-CD84B1F769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5142" y="2053242"/>
            <a:ext cx="4550536" cy="2177407"/>
          </a:xfrm>
          <a:prstGeom prst="rect">
            <a:avLst/>
          </a:prstGeom>
        </p:spPr>
      </p:pic>
      <p:grpSp>
        <p:nvGrpSpPr>
          <p:cNvPr id="204" name="グループ化 203">
            <a:extLst>
              <a:ext uri="{FF2B5EF4-FFF2-40B4-BE49-F238E27FC236}">
                <a16:creationId xmlns:a16="http://schemas.microsoft.com/office/drawing/2014/main" id="{CB3E50F0-B190-3ED4-0C10-A96455B3504B}"/>
              </a:ext>
            </a:extLst>
          </p:cNvPr>
          <p:cNvGrpSpPr/>
          <p:nvPr/>
        </p:nvGrpSpPr>
        <p:grpSpPr>
          <a:xfrm>
            <a:off x="555778" y="2184252"/>
            <a:ext cx="4774470" cy="2285853"/>
            <a:chOff x="555778" y="1599169"/>
            <a:chExt cx="4774470" cy="2285853"/>
          </a:xfrm>
        </p:grpSpPr>
        <p:sp>
          <p:nvSpPr>
            <p:cNvPr id="151" name="タイトル 15">
              <a:extLst>
                <a:ext uri="{FF2B5EF4-FFF2-40B4-BE49-F238E27FC236}">
                  <a16:creationId xmlns:a16="http://schemas.microsoft.com/office/drawing/2014/main" id="{FD889C93-1A03-1319-A978-690C167C477A}"/>
                </a:ext>
              </a:extLst>
            </p:cNvPr>
            <p:cNvSpPr txBox="1">
              <a:spLocks/>
            </p:cNvSpPr>
            <p:nvPr/>
          </p:nvSpPr>
          <p:spPr>
            <a:xfrm>
              <a:off x="555778" y="1923816"/>
              <a:ext cx="278113" cy="1258323"/>
            </a:xfrm>
            <a:prstGeom prst="rect">
              <a:avLst/>
            </a:prstGeom>
            <a:solidFill>
              <a:schemeClr val="bg1"/>
            </a:solidFill>
          </p:spPr>
          <p:txBody>
            <a:bodyPr vert="vert270" lIns="90000" tIns="45720" rIns="91440" bIns="45720" rtlCol="0" anchor="ctr">
              <a:no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SC hydration </a:t>
              </a:r>
            </a:p>
            <a:p>
              <a:pPr algn="ctr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(a.u..</a:t>
              </a:r>
              <a:r>
                <a:rPr lang="en-US" altLang="ja-JP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grpSp>
          <p:nvGrpSpPr>
            <p:cNvPr id="200" name="グループ化 199">
              <a:extLst>
                <a:ext uri="{FF2B5EF4-FFF2-40B4-BE49-F238E27FC236}">
                  <a16:creationId xmlns:a16="http://schemas.microsoft.com/office/drawing/2014/main" id="{90754E7A-A1E4-8C4C-E381-A0AC4C035060}"/>
                </a:ext>
              </a:extLst>
            </p:cNvPr>
            <p:cNvGrpSpPr/>
            <p:nvPr/>
          </p:nvGrpSpPr>
          <p:grpSpPr>
            <a:xfrm>
              <a:off x="819305" y="1599169"/>
              <a:ext cx="360484" cy="1990895"/>
              <a:chOff x="819305" y="1599169"/>
              <a:chExt cx="360484" cy="1990895"/>
            </a:xfrm>
          </p:grpSpPr>
          <p:sp>
            <p:nvSpPr>
              <p:cNvPr id="79" name="タイトル 15">
                <a:extLst>
                  <a:ext uri="{FF2B5EF4-FFF2-40B4-BE49-F238E27FC236}">
                    <a16:creationId xmlns:a16="http://schemas.microsoft.com/office/drawing/2014/main" id="{41C9A9C3-42BD-8A41-4FAE-366EA7C23F8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7646" y="3014720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タイトル 15">
                <a:extLst>
                  <a:ext uri="{FF2B5EF4-FFF2-40B4-BE49-F238E27FC236}">
                    <a16:creationId xmlns:a16="http://schemas.microsoft.com/office/drawing/2014/main" id="{9614F874-BC14-C4F3-934D-87C807B62F6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19305" y="3364199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タイトル 15">
                <a:extLst>
                  <a:ext uri="{FF2B5EF4-FFF2-40B4-BE49-F238E27FC236}">
                    <a16:creationId xmlns:a16="http://schemas.microsoft.com/office/drawing/2014/main" id="{834F6CA7-D8B1-2B06-4991-408A6BE912C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5239" y="1948648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タイトル 15">
                <a:extLst>
                  <a:ext uri="{FF2B5EF4-FFF2-40B4-BE49-F238E27FC236}">
                    <a16:creationId xmlns:a16="http://schemas.microsoft.com/office/drawing/2014/main" id="{ED6A5EA8-C3B7-ABB5-248E-68A320281E4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30463" y="2300576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タイトル 15">
                <a:extLst>
                  <a:ext uri="{FF2B5EF4-FFF2-40B4-BE49-F238E27FC236}">
                    <a16:creationId xmlns:a16="http://schemas.microsoft.com/office/drawing/2014/main" id="{5C9E1575-31B0-D9D4-E7E8-F0A53352364A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8561" y="2660008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タイトル 15">
                <a:extLst>
                  <a:ext uri="{FF2B5EF4-FFF2-40B4-BE49-F238E27FC236}">
                    <a16:creationId xmlns:a16="http://schemas.microsoft.com/office/drawing/2014/main" id="{C4AAC6CD-1044-D08D-BC19-78B36F8EDE3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25478" y="1599169"/>
                <a:ext cx="349326" cy="225865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99" name="正方形/長方形 198">
              <a:extLst>
                <a:ext uri="{FF2B5EF4-FFF2-40B4-BE49-F238E27FC236}">
                  <a16:creationId xmlns:a16="http://schemas.microsoft.com/office/drawing/2014/main" id="{176EC308-3111-F23C-B011-F89628E8038C}"/>
                </a:ext>
              </a:extLst>
            </p:cNvPr>
            <p:cNvSpPr/>
            <p:nvPr/>
          </p:nvSpPr>
          <p:spPr>
            <a:xfrm>
              <a:off x="1270948" y="3622970"/>
              <a:ext cx="4001807" cy="2620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FBA6166C-8468-CD99-C4CF-8D1828FC30D8}"/>
                </a:ext>
              </a:extLst>
            </p:cNvPr>
            <p:cNvGrpSpPr/>
            <p:nvPr/>
          </p:nvGrpSpPr>
          <p:grpSpPr>
            <a:xfrm>
              <a:off x="1362598" y="3598950"/>
              <a:ext cx="3967650" cy="223678"/>
              <a:chOff x="1362598" y="3598950"/>
              <a:chExt cx="3967650" cy="223678"/>
            </a:xfrm>
          </p:grpSpPr>
          <p:sp>
            <p:nvSpPr>
              <p:cNvPr id="116" name="タイトル 15">
                <a:extLst>
                  <a:ext uri="{FF2B5EF4-FFF2-40B4-BE49-F238E27FC236}">
                    <a16:creationId xmlns:a16="http://schemas.microsoft.com/office/drawing/2014/main" id="{155FFF8D-C005-B635-7794-D37FD07DD3C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515420" y="3616282"/>
                <a:ext cx="3126004" cy="15718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lIns="91440" tIns="45720" rIns="91440" bIns="45720" rtlCol="0" anchor="ctr">
                <a:normAutofit fontScale="40000" lnSpcReduction="20000"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endParaRPr lang="ja-JP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7" name="グループ化 116">
                <a:extLst>
                  <a:ext uri="{FF2B5EF4-FFF2-40B4-BE49-F238E27FC236}">
                    <a16:creationId xmlns:a16="http://schemas.microsoft.com/office/drawing/2014/main" id="{ACABB494-FEBE-6E83-04F5-8370B4FB43D2}"/>
                  </a:ext>
                </a:extLst>
              </p:cNvPr>
              <p:cNvGrpSpPr/>
              <p:nvPr/>
            </p:nvGrpSpPr>
            <p:grpSpPr>
              <a:xfrm>
                <a:off x="3589853" y="3598950"/>
                <a:ext cx="1740395" cy="220250"/>
                <a:chOff x="7316319" y="6547266"/>
                <a:chExt cx="1740395" cy="220250"/>
              </a:xfrm>
            </p:grpSpPr>
            <p:sp>
              <p:nvSpPr>
                <p:cNvPr id="122" name="タイトル 15">
                  <a:extLst>
                    <a:ext uri="{FF2B5EF4-FFF2-40B4-BE49-F238E27FC236}">
                      <a16:creationId xmlns:a16="http://schemas.microsoft.com/office/drawing/2014/main" id="{1E05EB6E-68C0-73C7-781C-E600C3B5D348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316319" y="6547266"/>
                  <a:ext cx="190400" cy="22025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タイトル 15">
                  <a:extLst>
                    <a:ext uri="{FF2B5EF4-FFF2-40B4-BE49-F238E27FC236}">
                      <a16:creationId xmlns:a16="http://schemas.microsoft.com/office/drawing/2014/main" id="{435B865A-B730-44E8-F276-57E0FC900497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979516" y="6547266"/>
                  <a:ext cx="316115" cy="20716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タイトル 15">
                  <a:extLst>
                    <a:ext uri="{FF2B5EF4-FFF2-40B4-BE49-F238E27FC236}">
                      <a16:creationId xmlns:a16="http://schemas.microsoft.com/office/drawing/2014/main" id="{6F47B903-824F-0ECB-BF60-3202FFB68D73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8662245" y="6548237"/>
                  <a:ext cx="394469" cy="21927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8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8" name="グループ化 117">
                <a:extLst>
                  <a:ext uri="{FF2B5EF4-FFF2-40B4-BE49-F238E27FC236}">
                    <a16:creationId xmlns:a16="http://schemas.microsoft.com/office/drawing/2014/main" id="{94BDEF9B-75AD-673D-FC6A-C918C95749F7}"/>
                  </a:ext>
                </a:extLst>
              </p:cNvPr>
              <p:cNvGrpSpPr/>
              <p:nvPr/>
            </p:nvGrpSpPr>
            <p:grpSpPr>
              <a:xfrm>
                <a:off x="1362598" y="3599921"/>
                <a:ext cx="1731308" cy="222707"/>
                <a:chOff x="5100787" y="6548237"/>
                <a:chExt cx="1731308" cy="222707"/>
              </a:xfrm>
            </p:grpSpPr>
            <p:sp>
              <p:nvSpPr>
                <p:cNvPr id="119" name="タイトル 15">
                  <a:extLst>
                    <a:ext uri="{FF2B5EF4-FFF2-40B4-BE49-F238E27FC236}">
                      <a16:creationId xmlns:a16="http://schemas.microsoft.com/office/drawing/2014/main" id="{86DC1C24-DE27-69C1-52AD-8E77885A78BC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100787" y="6550694"/>
                  <a:ext cx="190400" cy="22025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タイトル 15">
                  <a:extLst>
                    <a:ext uri="{FF2B5EF4-FFF2-40B4-BE49-F238E27FC236}">
                      <a16:creationId xmlns:a16="http://schemas.microsoft.com/office/drawing/2014/main" id="{203913AB-1C16-D974-8D44-DC7A085D3BC7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5753574" y="6553932"/>
                  <a:ext cx="334155" cy="20050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タイトル 15">
                  <a:extLst>
                    <a:ext uri="{FF2B5EF4-FFF2-40B4-BE49-F238E27FC236}">
                      <a16:creationId xmlns:a16="http://schemas.microsoft.com/office/drawing/2014/main" id="{123CFBA6-BAD4-DC38-E6D2-368BCC5A98CB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6437626" y="6548237"/>
                  <a:ext cx="394469" cy="21927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8</a:t>
                  </a:r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205" name="テキスト プレースホルダー 16">
            <a:extLst>
              <a:ext uri="{FF2B5EF4-FFF2-40B4-BE49-F238E27FC236}">
                <a16:creationId xmlns:a16="http://schemas.microsoft.com/office/drawing/2014/main" id="{87CD015B-742A-33E7-5CA3-BB64845075D3}"/>
              </a:ext>
            </a:extLst>
          </p:cNvPr>
          <p:cNvSpPr txBox="1">
            <a:spLocks/>
          </p:cNvSpPr>
          <p:nvPr/>
        </p:nvSpPr>
        <p:spPr>
          <a:xfrm>
            <a:off x="6335619" y="1466835"/>
            <a:ext cx="481832" cy="40878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kumimoji="1"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kumimoji="1"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600" b="0" dirty="0"/>
              <a:t>(b)</a:t>
            </a:r>
            <a:endParaRPr lang="ja-JP" altLang="en-US" sz="1600" b="0"/>
          </a:p>
        </p:txBody>
      </p:sp>
      <p:sp>
        <p:nvSpPr>
          <p:cNvPr id="236" name="タイトル 15">
            <a:extLst>
              <a:ext uri="{FF2B5EF4-FFF2-40B4-BE49-F238E27FC236}">
                <a16:creationId xmlns:a16="http://schemas.microsoft.com/office/drawing/2014/main" id="{8E68BEF7-CAD3-4984-C794-69D715732F37}"/>
              </a:ext>
            </a:extLst>
          </p:cNvPr>
          <p:cNvSpPr txBox="1">
            <a:spLocks/>
          </p:cNvSpPr>
          <p:nvPr/>
        </p:nvSpPr>
        <p:spPr>
          <a:xfrm>
            <a:off x="5283271" y="4175147"/>
            <a:ext cx="645392" cy="262052"/>
          </a:xfrm>
          <a:prstGeom prst="rect">
            <a:avLst/>
          </a:prstGeom>
          <a:solidFill>
            <a:schemeClr val="bg1"/>
          </a:solidFill>
        </p:spPr>
        <p:txBody>
          <a:bodyPr vert="horz" lIns="9000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237" name="タイトル 15">
            <a:extLst>
              <a:ext uri="{FF2B5EF4-FFF2-40B4-BE49-F238E27FC236}">
                <a16:creationId xmlns:a16="http://schemas.microsoft.com/office/drawing/2014/main" id="{D20F5E01-D6CC-11DB-90FC-38373EB08D4D}"/>
              </a:ext>
            </a:extLst>
          </p:cNvPr>
          <p:cNvSpPr txBox="1">
            <a:spLocks/>
          </p:cNvSpPr>
          <p:nvPr/>
        </p:nvSpPr>
        <p:spPr>
          <a:xfrm>
            <a:off x="11209182" y="4184273"/>
            <a:ext cx="645392" cy="262052"/>
          </a:xfrm>
          <a:prstGeom prst="rect">
            <a:avLst/>
          </a:prstGeom>
          <a:solidFill>
            <a:schemeClr val="bg1"/>
          </a:solidFill>
        </p:spPr>
        <p:txBody>
          <a:bodyPr vert="horz" lIns="9000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0D4395DA-5D7E-B740-51ED-F5068AD6B630}"/>
              </a:ext>
            </a:extLst>
          </p:cNvPr>
          <p:cNvSpPr/>
          <p:nvPr/>
        </p:nvSpPr>
        <p:spPr>
          <a:xfrm>
            <a:off x="6560133" y="219514"/>
            <a:ext cx="1710182" cy="4027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正方形/長方形 70">
            <a:extLst>
              <a:ext uri="{FF2B5EF4-FFF2-40B4-BE49-F238E27FC236}">
                <a16:creationId xmlns:a16="http://schemas.microsoft.com/office/drawing/2014/main" id="{6A65271F-26C9-31AB-62D3-D2CC3FEA9FED}"/>
              </a:ext>
            </a:extLst>
          </p:cNvPr>
          <p:cNvSpPr/>
          <p:nvPr/>
        </p:nvSpPr>
        <p:spPr>
          <a:xfrm>
            <a:off x="3507963" y="2169710"/>
            <a:ext cx="1689107" cy="5743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2600"/>
              </a:solidFill>
            </a:endParaRPr>
          </a:p>
        </p:txBody>
      </p: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CFA53ACF-705E-5B1E-FF7B-89AD7781869D}"/>
              </a:ext>
            </a:extLst>
          </p:cNvPr>
          <p:cNvGrpSpPr/>
          <p:nvPr/>
        </p:nvGrpSpPr>
        <p:grpSpPr>
          <a:xfrm>
            <a:off x="3589853" y="2315911"/>
            <a:ext cx="1546983" cy="532936"/>
            <a:chOff x="3589853" y="2599421"/>
            <a:chExt cx="1546983" cy="532936"/>
          </a:xfrm>
          <a:noFill/>
        </p:grpSpPr>
        <p:grpSp>
          <p:nvGrpSpPr>
            <p:cNvPr id="33" name="グループ化 32">
              <a:extLst>
                <a:ext uri="{FF2B5EF4-FFF2-40B4-BE49-F238E27FC236}">
                  <a16:creationId xmlns:a16="http://schemas.microsoft.com/office/drawing/2014/main" id="{DFDE2698-61B5-0699-7021-50E6EC169848}"/>
                </a:ext>
              </a:extLst>
            </p:cNvPr>
            <p:cNvGrpSpPr/>
            <p:nvPr/>
          </p:nvGrpSpPr>
          <p:grpSpPr>
            <a:xfrm>
              <a:off x="3589853" y="2599421"/>
              <a:ext cx="1546983" cy="532936"/>
              <a:chOff x="3589853" y="2599421"/>
              <a:chExt cx="1546983" cy="532936"/>
            </a:xfrm>
            <a:grpFill/>
          </p:grpSpPr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4D46F295-F684-86FF-B925-6B55ADECD096}"/>
                  </a:ext>
                </a:extLst>
              </p:cNvPr>
              <p:cNvSpPr/>
              <p:nvPr/>
            </p:nvSpPr>
            <p:spPr>
              <a:xfrm>
                <a:off x="3589853" y="2729574"/>
                <a:ext cx="1546983" cy="402783"/>
              </a:xfrm>
              <a:prstGeom prst="rect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2600"/>
                  </a:solidFill>
                </a:endParaRPr>
              </a:p>
            </p:txBody>
          </p:sp>
          <p:grpSp>
            <p:nvGrpSpPr>
              <p:cNvPr id="18" name="グループ化 17">
                <a:extLst>
                  <a:ext uri="{FF2B5EF4-FFF2-40B4-BE49-F238E27FC236}">
                    <a16:creationId xmlns:a16="http://schemas.microsoft.com/office/drawing/2014/main" id="{AC72FA8E-0BA6-9FF1-1E39-F879271F28FA}"/>
                  </a:ext>
                </a:extLst>
              </p:cNvPr>
              <p:cNvGrpSpPr/>
              <p:nvPr/>
            </p:nvGrpSpPr>
            <p:grpSpPr>
              <a:xfrm>
                <a:off x="3671228" y="2802204"/>
                <a:ext cx="1386445" cy="167769"/>
                <a:chOff x="3671228" y="2802204"/>
                <a:chExt cx="1386445" cy="167769"/>
              </a:xfrm>
              <a:grpFill/>
            </p:grpSpPr>
            <p:cxnSp>
              <p:nvCxnSpPr>
                <p:cNvPr id="3" name="直線コネクタ 2">
                  <a:extLst>
                    <a:ext uri="{FF2B5EF4-FFF2-40B4-BE49-F238E27FC236}">
                      <a16:creationId xmlns:a16="http://schemas.microsoft.com/office/drawing/2014/main" id="{9BD84689-994A-0584-3F48-FEE43967E9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81997" y="2802204"/>
                  <a:ext cx="1375676" cy="7110"/>
                </a:xfrm>
                <a:prstGeom prst="line">
                  <a:avLst/>
                </a:prstGeom>
                <a:grpFill/>
                <a:ln w="19050">
                  <a:solidFill>
                    <a:srgbClr val="FF26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" name="直線コネクタ 5">
                  <a:extLst>
                    <a:ext uri="{FF2B5EF4-FFF2-40B4-BE49-F238E27FC236}">
                      <a16:creationId xmlns:a16="http://schemas.microsoft.com/office/drawing/2014/main" id="{CDD4E7A0-22F2-2904-23D7-1FDD911A4A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71228" y="2962793"/>
                  <a:ext cx="710876" cy="7180"/>
                </a:xfrm>
                <a:prstGeom prst="line">
                  <a:avLst/>
                </a:prstGeom>
                <a:grpFill/>
                <a:ln w="19050">
                  <a:solidFill>
                    <a:srgbClr val="FF26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B0313D5D-8127-D17B-18DA-42FA06DCC321}"/>
                  </a:ext>
                </a:extLst>
              </p:cNvPr>
              <p:cNvGrpSpPr/>
              <p:nvPr/>
            </p:nvGrpSpPr>
            <p:grpSpPr>
              <a:xfrm>
                <a:off x="4149564" y="2599421"/>
                <a:ext cx="647937" cy="317641"/>
                <a:chOff x="7835984" y="439663"/>
                <a:chExt cx="647937" cy="317641"/>
              </a:xfrm>
              <a:grpFill/>
            </p:grpSpPr>
            <p:sp>
              <p:nvSpPr>
                <p:cNvPr id="29" name="タイトル 15">
                  <a:extLst>
                    <a:ext uri="{FF2B5EF4-FFF2-40B4-BE49-F238E27FC236}">
                      <a16:creationId xmlns:a16="http://schemas.microsoft.com/office/drawing/2014/main" id="{7413614C-32BA-E3F3-E3DB-91AF955E7901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936160" y="439663"/>
                  <a:ext cx="547761" cy="317641"/>
                </a:xfrm>
                <a:prstGeom prst="rect">
                  <a:avLst/>
                </a:prstGeom>
                <a:grp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FF26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30" name="タイトル 15">
                  <a:extLst>
                    <a:ext uri="{FF2B5EF4-FFF2-40B4-BE49-F238E27FC236}">
                      <a16:creationId xmlns:a16="http://schemas.microsoft.com/office/drawing/2014/main" id="{14CAF273-ED96-2A8D-8D79-811FBDDCDCB9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835984" y="439663"/>
                  <a:ext cx="547761" cy="317641"/>
                </a:xfrm>
                <a:prstGeom prst="rect">
                  <a:avLst/>
                </a:prstGeom>
                <a:grp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FF26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</p:grpSp>
        </p:grpSp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id="{64F17392-91BC-08EE-09C3-A4B80E623DA3}"/>
                </a:ext>
              </a:extLst>
            </p:cNvPr>
            <p:cNvGrpSpPr/>
            <p:nvPr/>
          </p:nvGrpSpPr>
          <p:grpSpPr>
            <a:xfrm>
              <a:off x="3808651" y="2757176"/>
              <a:ext cx="647937" cy="317641"/>
              <a:chOff x="7835984" y="439663"/>
              <a:chExt cx="647937" cy="317641"/>
            </a:xfrm>
            <a:grpFill/>
          </p:grpSpPr>
          <p:sp>
            <p:nvSpPr>
              <p:cNvPr id="54" name="タイトル 15">
                <a:extLst>
                  <a:ext uri="{FF2B5EF4-FFF2-40B4-BE49-F238E27FC236}">
                    <a16:creationId xmlns:a16="http://schemas.microsoft.com/office/drawing/2014/main" id="{D5DA87D5-0B8F-0BC1-0687-8D0E4A01FFC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936160" y="439663"/>
                <a:ext cx="547761" cy="317641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FF26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  <p:sp>
            <p:nvSpPr>
              <p:cNvPr id="55" name="タイトル 15">
                <a:extLst>
                  <a:ext uri="{FF2B5EF4-FFF2-40B4-BE49-F238E27FC236}">
                    <a16:creationId xmlns:a16="http://schemas.microsoft.com/office/drawing/2014/main" id="{9F4D7292-ABE2-BCEC-9A5D-426B649267A4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835984" y="439663"/>
                <a:ext cx="547761" cy="317641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FF26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</p:grpSp>
      </p:grp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FC8C5A88-CA57-BDFA-ACE2-6CE1070BCAFB}"/>
              </a:ext>
            </a:extLst>
          </p:cNvPr>
          <p:cNvSpPr/>
          <p:nvPr/>
        </p:nvSpPr>
        <p:spPr>
          <a:xfrm>
            <a:off x="1257706" y="2111176"/>
            <a:ext cx="1689107" cy="5743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04491631-CB54-303C-CBB1-43D60DA5EC01}"/>
              </a:ext>
            </a:extLst>
          </p:cNvPr>
          <p:cNvGrpSpPr/>
          <p:nvPr/>
        </p:nvGrpSpPr>
        <p:grpSpPr>
          <a:xfrm>
            <a:off x="1328430" y="2021296"/>
            <a:ext cx="1546983" cy="532936"/>
            <a:chOff x="3589853" y="2599421"/>
            <a:chExt cx="1546983" cy="532936"/>
          </a:xfrm>
        </p:grpSpPr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AE041454-309F-9AF5-AFBD-DBC0DC430E99}"/>
                </a:ext>
              </a:extLst>
            </p:cNvPr>
            <p:cNvGrpSpPr/>
            <p:nvPr/>
          </p:nvGrpSpPr>
          <p:grpSpPr>
            <a:xfrm>
              <a:off x="3589853" y="2599421"/>
              <a:ext cx="1546983" cy="532936"/>
              <a:chOff x="3589853" y="2599421"/>
              <a:chExt cx="1546983" cy="532936"/>
            </a:xfrm>
          </p:grpSpPr>
          <p:sp>
            <p:nvSpPr>
              <p:cNvPr id="78" name="正方形/長方形 77">
                <a:extLst>
                  <a:ext uri="{FF2B5EF4-FFF2-40B4-BE49-F238E27FC236}">
                    <a16:creationId xmlns:a16="http://schemas.microsoft.com/office/drawing/2014/main" id="{6C08CF74-7B35-6BDB-1E90-721D0FF5E6DC}"/>
                  </a:ext>
                </a:extLst>
              </p:cNvPr>
              <p:cNvSpPr/>
              <p:nvPr/>
            </p:nvSpPr>
            <p:spPr>
              <a:xfrm>
                <a:off x="3589853" y="2729574"/>
                <a:ext cx="1546983" cy="4027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0070C0"/>
                  </a:solidFill>
                </a:endParaRPr>
              </a:p>
            </p:txBody>
          </p:sp>
          <p:grpSp>
            <p:nvGrpSpPr>
              <p:cNvPr id="80" name="グループ化 79">
                <a:extLst>
                  <a:ext uri="{FF2B5EF4-FFF2-40B4-BE49-F238E27FC236}">
                    <a16:creationId xmlns:a16="http://schemas.microsoft.com/office/drawing/2014/main" id="{8F16C1FB-9E8A-D858-0261-D25A154F1D02}"/>
                  </a:ext>
                </a:extLst>
              </p:cNvPr>
              <p:cNvGrpSpPr/>
              <p:nvPr/>
            </p:nvGrpSpPr>
            <p:grpSpPr>
              <a:xfrm>
                <a:off x="3671228" y="2802204"/>
                <a:ext cx="1386445" cy="167769"/>
                <a:chOff x="3671228" y="2802204"/>
                <a:chExt cx="1386445" cy="167769"/>
              </a:xfrm>
            </p:grpSpPr>
            <p:cxnSp>
              <p:nvCxnSpPr>
                <p:cNvPr id="84" name="直線コネクタ 83">
                  <a:extLst>
                    <a:ext uri="{FF2B5EF4-FFF2-40B4-BE49-F238E27FC236}">
                      <a16:creationId xmlns:a16="http://schemas.microsoft.com/office/drawing/2014/main" id="{01602A29-5E1D-75CA-7000-A904049F52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81997" y="2802204"/>
                  <a:ext cx="1375676" cy="7110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線コネクタ 84">
                  <a:extLst>
                    <a:ext uri="{FF2B5EF4-FFF2-40B4-BE49-F238E27FC236}">
                      <a16:creationId xmlns:a16="http://schemas.microsoft.com/office/drawing/2014/main" id="{AFC7080B-4C42-4037-4BBE-5CCADD4A46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71228" y="2962793"/>
                  <a:ext cx="710876" cy="7180"/>
                </a:xfrm>
                <a:prstGeom prst="line">
                  <a:avLst/>
                </a:prstGeom>
                <a:ln w="1905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" name="グループ化 80">
                <a:extLst>
                  <a:ext uri="{FF2B5EF4-FFF2-40B4-BE49-F238E27FC236}">
                    <a16:creationId xmlns:a16="http://schemas.microsoft.com/office/drawing/2014/main" id="{FCFAC081-A0D0-9340-6310-890BE6572BC1}"/>
                  </a:ext>
                </a:extLst>
              </p:cNvPr>
              <p:cNvGrpSpPr/>
              <p:nvPr/>
            </p:nvGrpSpPr>
            <p:grpSpPr>
              <a:xfrm>
                <a:off x="4149564" y="2599421"/>
                <a:ext cx="647937" cy="317641"/>
                <a:chOff x="7835984" y="439663"/>
                <a:chExt cx="647937" cy="317641"/>
              </a:xfrm>
            </p:grpSpPr>
            <p:sp>
              <p:nvSpPr>
                <p:cNvPr id="82" name="タイトル 15">
                  <a:extLst>
                    <a:ext uri="{FF2B5EF4-FFF2-40B4-BE49-F238E27FC236}">
                      <a16:creationId xmlns:a16="http://schemas.microsoft.com/office/drawing/2014/main" id="{299F7FE5-C907-88C1-E238-A6B6C7154D78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936160" y="439663"/>
                  <a:ext cx="547761" cy="317641"/>
                </a:xfrm>
                <a:prstGeom prst="rect">
                  <a:avLst/>
                </a:prstGeom>
                <a:no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83" name="タイトル 15">
                  <a:extLst>
                    <a:ext uri="{FF2B5EF4-FFF2-40B4-BE49-F238E27FC236}">
                      <a16:creationId xmlns:a16="http://schemas.microsoft.com/office/drawing/2014/main" id="{FDD9172D-AA36-A265-7858-1246273EB2B7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835984" y="439663"/>
                  <a:ext cx="547761" cy="317641"/>
                </a:xfrm>
                <a:prstGeom prst="rect">
                  <a:avLst/>
                </a:prstGeom>
                <a:no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0070C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</p:grpSp>
        </p:grpSp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98861FBC-0EB5-E24C-2277-60D2D41415C0}"/>
                </a:ext>
              </a:extLst>
            </p:cNvPr>
            <p:cNvGrpSpPr/>
            <p:nvPr/>
          </p:nvGrpSpPr>
          <p:grpSpPr>
            <a:xfrm>
              <a:off x="3808651" y="2757176"/>
              <a:ext cx="647937" cy="317641"/>
              <a:chOff x="7835984" y="439663"/>
              <a:chExt cx="647937" cy="317641"/>
            </a:xfrm>
          </p:grpSpPr>
          <p:sp>
            <p:nvSpPr>
              <p:cNvPr id="76" name="タイトル 15">
                <a:extLst>
                  <a:ext uri="{FF2B5EF4-FFF2-40B4-BE49-F238E27FC236}">
                    <a16:creationId xmlns:a16="http://schemas.microsoft.com/office/drawing/2014/main" id="{59DA431D-FC4A-69EE-9E20-CC7E55E1164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936160" y="439663"/>
                <a:ext cx="547761" cy="31764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  <p:sp>
            <p:nvSpPr>
              <p:cNvPr id="77" name="タイトル 15">
                <a:extLst>
                  <a:ext uri="{FF2B5EF4-FFF2-40B4-BE49-F238E27FC236}">
                    <a16:creationId xmlns:a16="http://schemas.microsoft.com/office/drawing/2014/main" id="{FDA0C7C3-20AF-2F20-699A-A2B19240403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835984" y="439663"/>
                <a:ext cx="547761" cy="317641"/>
              </a:xfrm>
              <a:prstGeom prst="rect">
                <a:avLst/>
              </a:prstGeom>
              <a:no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0070C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</p:grpSp>
      </p:grp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B0DAEF2A-B63A-DB16-D5B4-5DD29269C6B6}"/>
              </a:ext>
            </a:extLst>
          </p:cNvPr>
          <p:cNvGrpSpPr/>
          <p:nvPr/>
        </p:nvGrpSpPr>
        <p:grpSpPr>
          <a:xfrm>
            <a:off x="1403318" y="2328554"/>
            <a:ext cx="1386445" cy="475396"/>
            <a:chOff x="3671228" y="2599421"/>
            <a:chExt cx="1386445" cy="475396"/>
          </a:xfrm>
          <a:noFill/>
        </p:grpSpPr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97A2C378-71B0-F7BB-9799-0462518CED20}"/>
                </a:ext>
              </a:extLst>
            </p:cNvPr>
            <p:cNvGrpSpPr/>
            <p:nvPr/>
          </p:nvGrpSpPr>
          <p:grpSpPr>
            <a:xfrm>
              <a:off x="3671228" y="2599421"/>
              <a:ext cx="1386445" cy="370552"/>
              <a:chOff x="3671228" y="2599421"/>
              <a:chExt cx="1386445" cy="370552"/>
            </a:xfrm>
            <a:grpFill/>
          </p:grpSpPr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70DB5E8D-596E-5C79-AEFD-9B246A167D2F}"/>
                  </a:ext>
                </a:extLst>
              </p:cNvPr>
              <p:cNvGrpSpPr/>
              <p:nvPr/>
            </p:nvGrpSpPr>
            <p:grpSpPr>
              <a:xfrm>
                <a:off x="3671228" y="2802204"/>
                <a:ext cx="1386445" cy="167769"/>
                <a:chOff x="3671228" y="2802204"/>
                <a:chExt cx="1386445" cy="167769"/>
              </a:xfrm>
              <a:grpFill/>
            </p:grpSpPr>
            <p:cxnSp>
              <p:nvCxnSpPr>
                <p:cNvPr id="68" name="直線コネクタ 67">
                  <a:extLst>
                    <a:ext uri="{FF2B5EF4-FFF2-40B4-BE49-F238E27FC236}">
                      <a16:creationId xmlns:a16="http://schemas.microsoft.com/office/drawing/2014/main" id="{823F2B5A-AB0D-1433-F71B-61153F5F99E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81997" y="2802204"/>
                  <a:ext cx="1375676" cy="7110"/>
                </a:xfrm>
                <a:prstGeom prst="line">
                  <a:avLst/>
                </a:prstGeom>
                <a:grpFill/>
                <a:ln w="19050">
                  <a:solidFill>
                    <a:srgbClr val="FF26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直線コネクタ 68">
                  <a:extLst>
                    <a:ext uri="{FF2B5EF4-FFF2-40B4-BE49-F238E27FC236}">
                      <a16:creationId xmlns:a16="http://schemas.microsoft.com/office/drawing/2014/main" id="{5ACC40B4-6A46-9E34-9D58-0D5019F6CFE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71228" y="2962793"/>
                  <a:ext cx="710876" cy="7180"/>
                </a:xfrm>
                <a:prstGeom prst="line">
                  <a:avLst/>
                </a:prstGeom>
                <a:grpFill/>
                <a:ln w="19050">
                  <a:solidFill>
                    <a:srgbClr val="FF26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" name="グループ化 63">
                <a:extLst>
                  <a:ext uri="{FF2B5EF4-FFF2-40B4-BE49-F238E27FC236}">
                    <a16:creationId xmlns:a16="http://schemas.microsoft.com/office/drawing/2014/main" id="{9271C04C-2191-68D1-A085-CDF6334D2780}"/>
                  </a:ext>
                </a:extLst>
              </p:cNvPr>
              <p:cNvGrpSpPr/>
              <p:nvPr/>
            </p:nvGrpSpPr>
            <p:grpSpPr>
              <a:xfrm>
                <a:off x="4149564" y="2599421"/>
                <a:ext cx="647937" cy="317641"/>
                <a:chOff x="7835984" y="439663"/>
                <a:chExt cx="647937" cy="317641"/>
              </a:xfrm>
              <a:grpFill/>
            </p:grpSpPr>
            <p:sp>
              <p:nvSpPr>
                <p:cNvPr id="65" name="タイトル 15">
                  <a:extLst>
                    <a:ext uri="{FF2B5EF4-FFF2-40B4-BE49-F238E27FC236}">
                      <a16:creationId xmlns:a16="http://schemas.microsoft.com/office/drawing/2014/main" id="{288BC3F4-A43C-F424-F570-130B2429E0EA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936160" y="439663"/>
                  <a:ext cx="547761" cy="317641"/>
                </a:xfrm>
                <a:prstGeom prst="rect">
                  <a:avLst/>
                </a:prstGeom>
                <a:grp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FF26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  <p:sp>
              <p:nvSpPr>
                <p:cNvPr id="66" name="タイトル 15">
                  <a:extLst>
                    <a:ext uri="{FF2B5EF4-FFF2-40B4-BE49-F238E27FC236}">
                      <a16:creationId xmlns:a16="http://schemas.microsoft.com/office/drawing/2014/main" id="{A88B7299-CFAB-7DC4-50E1-CEA002181664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835984" y="439663"/>
                  <a:ext cx="547761" cy="317641"/>
                </a:xfrm>
                <a:prstGeom prst="rect">
                  <a:avLst/>
                </a:prstGeom>
                <a:grpFill/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kumimoji="1"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ja-JP" altLang="en-US" sz="110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＊</a:t>
                  </a:r>
                </a:p>
              </p:txBody>
            </p:sp>
          </p:grpSp>
        </p:grpSp>
        <p:grpSp>
          <p:nvGrpSpPr>
            <p:cNvPr id="59" name="グループ化 58">
              <a:extLst>
                <a:ext uri="{FF2B5EF4-FFF2-40B4-BE49-F238E27FC236}">
                  <a16:creationId xmlns:a16="http://schemas.microsoft.com/office/drawing/2014/main" id="{87121446-4EA6-879F-91AF-718B203A1687}"/>
                </a:ext>
              </a:extLst>
            </p:cNvPr>
            <p:cNvGrpSpPr/>
            <p:nvPr/>
          </p:nvGrpSpPr>
          <p:grpSpPr>
            <a:xfrm>
              <a:off x="3808651" y="2757176"/>
              <a:ext cx="647937" cy="317641"/>
              <a:chOff x="7835984" y="439663"/>
              <a:chExt cx="647937" cy="317641"/>
            </a:xfrm>
            <a:grpFill/>
          </p:grpSpPr>
          <p:sp>
            <p:nvSpPr>
              <p:cNvPr id="60" name="タイトル 15">
                <a:extLst>
                  <a:ext uri="{FF2B5EF4-FFF2-40B4-BE49-F238E27FC236}">
                    <a16:creationId xmlns:a16="http://schemas.microsoft.com/office/drawing/2014/main" id="{153025BF-0FEC-7356-9583-4CDED75B7FA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936160" y="439663"/>
                <a:ext cx="547761" cy="317641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FF26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  <p:sp>
            <p:nvSpPr>
              <p:cNvPr id="61" name="タイトル 15">
                <a:extLst>
                  <a:ext uri="{FF2B5EF4-FFF2-40B4-BE49-F238E27FC236}">
                    <a16:creationId xmlns:a16="http://schemas.microsoft.com/office/drawing/2014/main" id="{61DF4FD9-5B81-1D78-F48F-1EB2BFBE76A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835984" y="439663"/>
                <a:ext cx="547761" cy="317641"/>
              </a:xfrm>
              <a:prstGeom prst="rect">
                <a:avLst/>
              </a:prstGeom>
              <a:grpFill/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kumimoji="1"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ja-JP" altLang="en-US" sz="110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＊</a:t>
                </a:r>
              </a:p>
            </p:txBody>
          </p:sp>
        </p:grpSp>
      </p:grpSp>
      <p:sp>
        <p:nvSpPr>
          <p:cNvPr id="5" name="コンテンツ プレースホルダー 2">
            <a:extLst>
              <a:ext uri="{FF2B5EF4-FFF2-40B4-BE49-F238E27FC236}">
                <a16:creationId xmlns:a16="http://schemas.microsoft.com/office/drawing/2014/main" id="{D57F7CB1-DC73-9202-4301-5FC323BF919F}"/>
              </a:ext>
            </a:extLst>
          </p:cNvPr>
          <p:cNvSpPr txBox="1">
            <a:spLocks/>
          </p:cNvSpPr>
          <p:nvPr/>
        </p:nvSpPr>
        <p:spPr>
          <a:xfrm>
            <a:off x="321276" y="5092483"/>
            <a:ext cx="11504140" cy="56511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buNone/>
            </a:pPr>
            <a:r>
              <a:rPr lang="en-US" altLang="ja-JP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1 </a:t>
            </a:r>
            <a:r>
              <a:rPr lang="en-US" altLang="ja-JP" sz="16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anges in SC hydration and TEWL at 0, 14, and 28 days with the CM and PJ in the patients with and without AD.</a:t>
            </a:r>
            <a:endParaRPr lang="ja-JP" altLang="ja-JP" sz="1600" kern="1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4884A366-9611-6DAC-0733-0EBBD7705D17}"/>
              </a:ext>
            </a:extLst>
          </p:cNvPr>
          <p:cNvSpPr txBox="1">
            <a:spLocks/>
          </p:cNvSpPr>
          <p:nvPr/>
        </p:nvSpPr>
        <p:spPr>
          <a:xfrm>
            <a:off x="321276" y="5587893"/>
            <a:ext cx="11504140" cy="72419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6350" indent="-6350" algn="just">
              <a:lnSpc>
                <a:spcPct val="100000"/>
              </a:lnSpc>
              <a:spcAft>
                <a:spcPts val="20"/>
              </a:spcAft>
              <a:buNone/>
            </a:pP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ean values</a:t>
            </a:r>
            <a:r>
              <a:rPr lang="en-US" altLang="ja-JP" sz="1400" kern="100" dirty="0">
                <a:effectLst/>
                <a:latin typeface="ＭＳ 明朝" panose="02020609040205080304" pitchFamily="49" charset="-128"/>
                <a:ea typeface="Times New Roman" panose="02020603050405020304" pitchFamily="18" charset="0"/>
                <a:cs typeface="ＭＳ 明朝" panose="02020609040205080304" pitchFamily="49" charset="-128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f (a) SC hydration and (b) TEWL at 0, 14, and 28 days with CM (circles, red line) and PJ (squares, blue line) in patients with and without AD (n = 23). Error bars indicate 95% confidence intervals. Measurements were performed </a:t>
            </a:r>
            <a:r>
              <a:rPr lang="en-US" altLang="ja-JP" sz="1400" kern="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using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ewameter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a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rneometer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values were calculated by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lch’s t-test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0 vs 14 days and 0 vs 28 days. *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 </a:t>
            </a:r>
          </a:p>
          <a:p>
            <a:pPr marL="6350" indent="-6350" algn="just">
              <a:lnSpc>
                <a:spcPct val="100000"/>
              </a:lnSpc>
              <a:spcBef>
                <a:spcPts val="20"/>
              </a:spcBef>
              <a:spcAft>
                <a:spcPts val="20"/>
              </a:spcAft>
              <a:buNone/>
            </a:pP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, atopic dermatitis; CM, cream-type moisturizer; PJ, petroleum jelly; SC, stratum corneum; TEWL, </a:t>
            </a:r>
            <a:r>
              <a:rPr lang="en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epidermal</a:t>
            </a:r>
            <a:r>
              <a:rPr lang="en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ter loss.</a:t>
            </a:r>
          </a:p>
          <a:p>
            <a:pPr marL="0" indent="0" algn="just">
              <a:lnSpc>
                <a:spcPct val="100000"/>
              </a:lnSpc>
              <a:buNone/>
            </a:pP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68583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263</TotalTime>
  <Words>3058</Words>
  <Application>Microsoft Macintosh PowerPoint</Application>
  <PresentationFormat>ワイド画面</PresentationFormat>
  <Paragraphs>1240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田 理紗</dc:creator>
  <cp:lastModifiedBy>福田 理紗</cp:lastModifiedBy>
  <cp:revision>74</cp:revision>
  <cp:lastPrinted>2024-12-17T01:33:23Z</cp:lastPrinted>
  <dcterms:created xsi:type="dcterms:W3CDTF">2022-11-22T12:00:12Z</dcterms:created>
  <dcterms:modified xsi:type="dcterms:W3CDTF">2025-10-17T14:07:35Z</dcterms:modified>
</cp:coreProperties>
</file>